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5" d="100"/>
          <a:sy n="95" d="100"/>
        </p:scale>
        <p:origin x="2748" y="7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7147444004424525E-2"/>
          <c:y val="3.7376247316360099E-2"/>
          <c:w val="0.96285255599557551"/>
          <c:h val="0.684829444913964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684'!$Q$2</c:f>
              <c:strCache>
                <c:ptCount val="1"/>
                <c:pt idx="0">
                  <c:v>Pre-REP</c:v>
                </c:pt>
              </c:strCache>
            </c:strRef>
          </c:tx>
          <c:spPr>
            <a:solidFill>
              <a:sysClr val="window" lastClr="FFFFFF"/>
            </a:solidFill>
            <a:ln w="12700" cap="flat" cmpd="sng" algn="ctr">
              <a:solidFill>
                <a:schemeClr val="tx1"/>
              </a:solidFill>
              <a:prstDash val="solid"/>
            </a:ln>
            <a:effectLst/>
          </c:spPr>
          <c:invertIfNegative val="0"/>
          <c:dPt>
            <c:idx val="15"/>
            <c:invertIfNegative val="0"/>
            <c:bubble3D val="0"/>
          </c:dPt>
          <c:cat>
            <c:strRef>
              <c:f>'2684'!$P$3:$P$47</c:f>
              <c:strCache>
                <c:ptCount val="45"/>
                <c:pt idx="0">
                  <c:v>TRAV10</c:v>
                </c:pt>
                <c:pt idx="1">
                  <c:v>TRAV11</c:v>
                </c:pt>
                <c:pt idx="2">
                  <c:v>TRAV1-1</c:v>
                </c:pt>
                <c:pt idx="3">
                  <c:v>TRAV1-2</c:v>
                </c:pt>
                <c:pt idx="4">
                  <c:v>TRAV12-1</c:v>
                </c:pt>
                <c:pt idx="5">
                  <c:v>TRAV12-2</c:v>
                </c:pt>
                <c:pt idx="6">
                  <c:v>TRAV12-3</c:v>
                </c:pt>
                <c:pt idx="7">
                  <c:v>TRAV13-1</c:v>
                </c:pt>
                <c:pt idx="8">
                  <c:v>TRAV13-2</c:v>
                </c:pt>
                <c:pt idx="9">
                  <c:v>TRAV14_DV4</c:v>
                </c:pt>
                <c:pt idx="10">
                  <c:v>TRAV16</c:v>
                </c:pt>
                <c:pt idx="11">
                  <c:v>TRAV17</c:v>
                </c:pt>
                <c:pt idx="12">
                  <c:v>TRAV18</c:v>
                </c:pt>
                <c:pt idx="13">
                  <c:v>TRAV19</c:v>
                </c:pt>
                <c:pt idx="14">
                  <c:v>TRAV2</c:v>
                </c:pt>
                <c:pt idx="15">
                  <c:v>TRAV20</c:v>
                </c:pt>
                <c:pt idx="16">
                  <c:v>TRAV21</c:v>
                </c:pt>
                <c:pt idx="17">
                  <c:v>TRAV22</c:v>
                </c:pt>
                <c:pt idx="18">
                  <c:v>TRAV23_DV6</c:v>
                </c:pt>
                <c:pt idx="19">
                  <c:v>TRAV24</c:v>
                </c:pt>
                <c:pt idx="20">
                  <c:v>TRAV25</c:v>
                </c:pt>
                <c:pt idx="21">
                  <c:v>TRAV26-1</c:v>
                </c:pt>
                <c:pt idx="22">
                  <c:v>TRAV26-2</c:v>
                </c:pt>
                <c:pt idx="23">
                  <c:v>TRAV27</c:v>
                </c:pt>
                <c:pt idx="24">
                  <c:v>TRAV29_DV5</c:v>
                </c:pt>
                <c:pt idx="25">
                  <c:v>TRAV3</c:v>
                </c:pt>
                <c:pt idx="26">
                  <c:v>TRAV30</c:v>
                </c:pt>
                <c:pt idx="27">
                  <c:v>TRAV34</c:v>
                </c:pt>
                <c:pt idx="28">
                  <c:v>TRAV35</c:v>
                </c:pt>
                <c:pt idx="29">
                  <c:v>TRAV36_DV7</c:v>
                </c:pt>
                <c:pt idx="30">
                  <c:v>TRAV38-1</c:v>
                </c:pt>
                <c:pt idx="31">
                  <c:v>TRAV38-2_DV8</c:v>
                </c:pt>
                <c:pt idx="32">
                  <c:v>TRAV39</c:v>
                </c:pt>
                <c:pt idx="33">
                  <c:v>TRAV4</c:v>
                </c:pt>
                <c:pt idx="34">
                  <c:v>TRAV40</c:v>
                </c:pt>
                <c:pt idx="35">
                  <c:v>TRAV41</c:v>
                </c:pt>
                <c:pt idx="36">
                  <c:v>TRAV5</c:v>
                </c:pt>
                <c:pt idx="37">
                  <c:v>TRAV6</c:v>
                </c:pt>
                <c:pt idx="38">
                  <c:v>TRAV7</c:v>
                </c:pt>
                <c:pt idx="39">
                  <c:v>TRAV8-1</c:v>
                </c:pt>
                <c:pt idx="40">
                  <c:v>TRAV8-2</c:v>
                </c:pt>
                <c:pt idx="41">
                  <c:v>TRAV8-3</c:v>
                </c:pt>
                <c:pt idx="42">
                  <c:v>TRAV8-6</c:v>
                </c:pt>
                <c:pt idx="43">
                  <c:v>TRAV9-1</c:v>
                </c:pt>
                <c:pt idx="44">
                  <c:v>TRAV9-2</c:v>
                </c:pt>
              </c:strCache>
            </c:strRef>
          </c:cat>
          <c:val>
            <c:numRef>
              <c:f>'2684'!$Q$3:$Q$47</c:f>
              <c:numCache>
                <c:formatCode>General</c:formatCode>
                <c:ptCount val="45"/>
                <c:pt idx="0">
                  <c:v>3.7306591122142564E-3</c:v>
                </c:pt>
                <c:pt idx="1">
                  <c:v>-3.2544047574635006E-3</c:v>
                </c:pt>
                <c:pt idx="2">
                  <c:v>3.0956533058799146E-3</c:v>
                </c:pt>
                <c:pt idx="3">
                  <c:v>1.6328380552629675</c:v>
                </c:pt>
                <c:pt idx="4">
                  <c:v>2.4050844914913189E-2</c:v>
                </c:pt>
                <c:pt idx="5">
                  <c:v>0.11803170425239572</c:v>
                </c:pt>
                <c:pt idx="6">
                  <c:v>3.0083400075089434E-2</c:v>
                </c:pt>
                <c:pt idx="7">
                  <c:v>7.4216303615326162E-2</c:v>
                </c:pt>
                <c:pt idx="8">
                  <c:v>0.33139365518073449</c:v>
                </c:pt>
                <c:pt idx="9">
                  <c:v>8.3106384904006944E-2</c:v>
                </c:pt>
                <c:pt idx="10">
                  <c:v>0.7149371622066768</c:v>
                </c:pt>
                <c:pt idx="11">
                  <c:v>0.85273342218122883</c:v>
                </c:pt>
                <c:pt idx="12">
                  <c:v>0.61714626803118822</c:v>
                </c:pt>
                <c:pt idx="13">
                  <c:v>0.3977517619426732</c:v>
                </c:pt>
                <c:pt idx="14">
                  <c:v>2.4050844914913189E-2</c:v>
                </c:pt>
                <c:pt idx="15">
                  <c:v>48.161300999896007</c:v>
                </c:pt>
                <c:pt idx="16">
                  <c:v>3.8020972654268695E-2</c:v>
                </c:pt>
                <c:pt idx="17">
                  <c:v>0.17010218037181174</c:v>
                </c:pt>
                <c:pt idx="18">
                  <c:v>3.2305920397259623E-2</c:v>
                </c:pt>
                <c:pt idx="19">
                  <c:v>3.0956533058799146E-3</c:v>
                </c:pt>
                <c:pt idx="20">
                  <c:v>1.7700786851569769E-2</c:v>
                </c:pt>
                <c:pt idx="21">
                  <c:v>4.8498568458785335E-2</c:v>
                </c:pt>
                <c:pt idx="22">
                  <c:v>3.9290984266937376E-2</c:v>
                </c:pt>
                <c:pt idx="23">
                  <c:v>9.7632142723905E-3</c:v>
                </c:pt>
                <c:pt idx="24">
                  <c:v>2.2780833302244501E-2</c:v>
                </c:pt>
                <c:pt idx="25">
                  <c:v>9.7632142723905E-3</c:v>
                </c:pt>
                <c:pt idx="26">
                  <c:v>0.1075541084478791</c:v>
                </c:pt>
                <c:pt idx="27">
                  <c:v>4.3656649185485983E-3</c:v>
                </c:pt>
                <c:pt idx="28">
                  <c:v>8.5011402323009966E-2</c:v>
                </c:pt>
                <c:pt idx="29">
                  <c:v>13.409338236636497</c:v>
                </c:pt>
                <c:pt idx="30">
                  <c:v>5.6356765312172803E-3</c:v>
                </c:pt>
                <c:pt idx="31">
                  <c:v>1.7065781045235429E-2</c:v>
                </c:pt>
                <c:pt idx="32">
                  <c:v>2.9448394268755087E-2</c:v>
                </c:pt>
                <c:pt idx="33">
                  <c:v>5.1673597490457045E-2</c:v>
                </c:pt>
                <c:pt idx="34">
                  <c:v>-2.6193989511291587E-3</c:v>
                </c:pt>
                <c:pt idx="35">
                  <c:v>1.4843260723065233E-2</c:v>
                </c:pt>
                <c:pt idx="36">
                  <c:v>6.2706823375516226E-3</c:v>
                </c:pt>
                <c:pt idx="37">
                  <c:v>1.8970798464238457E-2</c:v>
                </c:pt>
                <c:pt idx="38">
                  <c:v>-2.301896047961988E-3</c:v>
                </c:pt>
                <c:pt idx="39">
                  <c:v>3.0400902978256601E-2</c:v>
                </c:pt>
                <c:pt idx="40">
                  <c:v>21.085288423606023</c:v>
                </c:pt>
                <c:pt idx="41">
                  <c:v>8.3106384904006944E-2</c:v>
                </c:pt>
                <c:pt idx="42">
                  <c:v>0.13295434070125275</c:v>
                </c:pt>
                <c:pt idx="43">
                  <c:v>-1.6668902416276468E-3</c:v>
                </c:pt>
                <c:pt idx="44">
                  <c:v>11.468125486672417</c:v>
                </c:pt>
              </c:numCache>
            </c:numRef>
          </c:val>
        </c:ser>
        <c:ser>
          <c:idx val="1"/>
          <c:order val="1"/>
          <c:tx>
            <c:strRef>
              <c:f>'2684'!$R$2</c:f>
              <c:strCache>
                <c:ptCount val="1"/>
                <c:pt idx="0">
                  <c:v>Bag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2684'!$P$3:$P$47</c:f>
              <c:strCache>
                <c:ptCount val="45"/>
                <c:pt idx="0">
                  <c:v>TRAV10</c:v>
                </c:pt>
                <c:pt idx="1">
                  <c:v>TRAV11</c:v>
                </c:pt>
                <c:pt idx="2">
                  <c:v>TRAV1-1</c:v>
                </c:pt>
                <c:pt idx="3">
                  <c:v>TRAV1-2</c:v>
                </c:pt>
                <c:pt idx="4">
                  <c:v>TRAV12-1</c:v>
                </c:pt>
                <c:pt idx="5">
                  <c:v>TRAV12-2</c:v>
                </c:pt>
                <c:pt idx="6">
                  <c:v>TRAV12-3</c:v>
                </c:pt>
                <c:pt idx="7">
                  <c:v>TRAV13-1</c:v>
                </c:pt>
                <c:pt idx="8">
                  <c:v>TRAV13-2</c:v>
                </c:pt>
                <c:pt idx="9">
                  <c:v>TRAV14_DV4</c:v>
                </c:pt>
                <c:pt idx="10">
                  <c:v>TRAV16</c:v>
                </c:pt>
                <c:pt idx="11">
                  <c:v>TRAV17</c:v>
                </c:pt>
                <c:pt idx="12">
                  <c:v>TRAV18</c:v>
                </c:pt>
                <c:pt idx="13">
                  <c:v>TRAV19</c:v>
                </c:pt>
                <c:pt idx="14">
                  <c:v>TRAV2</c:v>
                </c:pt>
                <c:pt idx="15">
                  <c:v>TRAV20</c:v>
                </c:pt>
                <c:pt idx="16">
                  <c:v>TRAV21</c:v>
                </c:pt>
                <c:pt idx="17">
                  <c:v>TRAV22</c:v>
                </c:pt>
                <c:pt idx="18">
                  <c:v>TRAV23_DV6</c:v>
                </c:pt>
                <c:pt idx="19">
                  <c:v>TRAV24</c:v>
                </c:pt>
                <c:pt idx="20">
                  <c:v>TRAV25</c:v>
                </c:pt>
                <c:pt idx="21">
                  <c:v>TRAV26-1</c:v>
                </c:pt>
                <c:pt idx="22">
                  <c:v>TRAV26-2</c:v>
                </c:pt>
                <c:pt idx="23">
                  <c:v>TRAV27</c:v>
                </c:pt>
                <c:pt idx="24">
                  <c:v>TRAV29_DV5</c:v>
                </c:pt>
                <c:pt idx="25">
                  <c:v>TRAV3</c:v>
                </c:pt>
                <c:pt idx="26">
                  <c:v>TRAV30</c:v>
                </c:pt>
                <c:pt idx="27">
                  <c:v>TRAV34</c:v>
                </c:pt>
                <c:pt idx="28">
                  <c:v>TRAV35</c:v>
                </c:pt>
                <c:pt idx="29">
                  <c:v>TRAV36_DV7</c:v>
                </c:pt>
                <c:pt idx="30">
                  <c:v>TRAV38-1</c:v>
                </c:pt>
                <c:pt idx="31">
                  <c:v>TRAV38-2_DV8</c:v>
                </c:pt>
                <c:pt idx="32">
                  <c:v>TRAV39</c:v>
                </c:pt>
                <c:pt idx="33">
                  <c:v>TRAV4</c:v>
                </c:pt>
                <c:pt idx="34">
                  <c:v>TRAV40</c:v>
                </c:pt>
                <c:pt idx="35">
                  <c:v>TRAV41</c:v>
                </c:pt>
                <c:pt idx="36">
                  <c:v>TRAV5</c:v>
                </c:pt>
                <c:pt idx="37">
                  <c:v>TRAV6</c:v>
                </c:pt>
                <c:pt idx="38">
                  <c:v>TRAV7</c:v>
                </c:pt>
                <c:pt idx="39">
                  <c:v>TRAV8-1</c:v>
                </c:pt>
                <c:pt idx="40">
                  <c:v>TRAV8-2</c:v>
                </c:pt>
                <c:pt idx="41">
                  <c:v>TRAV8-3</c:v>
                </c:pt>
                <c:pt idx="42">
                  <c:v>TRAV8-6</c:v>
                </c:pt>
                <c:pt idx="43">
                  <c:v>TRAV9-1</c:v>
                </c:pt>
                <c:pt idx="44">
                  <c:v>TRAV9-2</c:v>
                </c:pt>
              </c:strCache>
            </c:strRef>
          </c:cat>
          <c:val>
            <c:numRef>
              <c:f>'2684'!$R$3:$R$47</c:f>
              <c:numCache>
                <c:formatCode>General</c:formatCode>
                <c:ptCount val="45"/>
                <c:pt idx="0">
                  <c:v>0.50541340600162088</c:v>
                </c:pt>
                <c:pt idx="1">
                  <c:v>-3.1084343536956806E-3</c:v>
                </c:pt>
                <c:pt idx="2">
                  <c:v>0.69606404636162267</c:v>
                </c:pt>
                <c:pt idx="3">
                  <c:v>2.8299817052870866</c:v>
                </c:pt>
                <c:pt idx="4">
                  <c:v>0.89248105769659614</c:v>
                </c:pt>
                <c:pt idx="5">
                  <c:v>1.8987127928291572</c:v>
                </c:pt>
                <c:pt idx="6">
                  <c:v>2.8930513878258393</c:v>
                </c:pt>
                <c:pt idx="7">
                  <c:v>5.9167921678266229</c:v>
                </c:pt>
                <c:pt idx="8">
                  <c:v>2.1272052427124106</c:v>
                </c:pt>
                <c:pt idx="9">
                  <c:v>12.615152851628119</c:v>
                </c:pt>
                <c:pt idx="10">
                  <c:v>2.3719156109627719</c:v>
                </c:pt>
                <c:pt idx="11">
                  <c:v>1.690042243172369</c:v>
                </c:pt>
                <c:pt idx="12">
                  <c:v>0.20376012437341395</c:v>
                </c:pt>
                <c:pt idx="13">
                  <c:v>0.72417510486460956</c:v>
                </c:pt>
                <c:pt idx="14">
                  <c:v>4.6179171057142483</c:v>
                </c:pt>
                <c:pt idx="15">
                  <c:v>6.3045806158934692</c:v>
                </c:pt>
                <c:pt idx="16">
                  <c:v>1.7833853733297229</c:v>
                </c:pt>
                <c:pt idx="17">
                  <c:v>0.47297756926740503</c:v>
                </c:pt>
                <c:pt idx="18">
                  <c:v>3.7634130068606297</c:v>
                </c:pt>
                <c:pt idx="19">
                  <c:v>0.77679324001122629</c:v>
                </c:pt>
                <c:pt idx="20">
                  <c:v>0.78580319465961967</c:v>
                </c:pt>
                <c:pt idx="21">
                  <c:v>2.7269078241094675</c:v>
                </c:pt>
                <c:pt idx="22">
                  <c:v>1.1656628826358801</c:v>
                </c:pt>
                <c:pt idx="23">
                  <c:v>1.2788279130196998</c:v>
                </c:pt>
                <c:pt idx="24">
                  <c:v>2.5856317352226608</c:v>
                </c:pt>
                <c:pt idx="25">
                  <c:v>0.55226517017326593</c:v>
                </c:pt>
                <c:pt idx="26">
                  <c:v>0.6236240109885407</c:v>
                </c:pt>
                <c:pt idx="27">
                  <c:v>0.3569293533960996</c:v>
                </c:pt>
                <c:pt idx="28">
                  <c:v>2.3484897288769493</c:v>
                </c:pt>
                <c:pt idx="29">
                  <c:v>6.2598912408374385</c:v>
                </c:pt>
                <c:pt idx="30">
                  <c:v>0.63191316926506236</c:v>
                </c:pt>
                <c:pt idx="31">
                  <c:v>1.5538117288886626</c:v>
                </c:pt>
                <c:pt idx="32">
                  <c:v>1.2204434068981111</c:v>
                </c:pt>
                <c:pt idx="33">
                  <c:v>0.8402233207359151</c:v>
                </c:pt>
                <c:pt idx="34">
                  <c:v>6.6088017345964672E-2</c:v>
                </c:pt>
                <c:pt idx="35">
                  <c:v>1.25936641097917</c:v>
                </c:pt>
                <c:pt idx="36">
                  <c:v>0.56487910668101649</c:v>
                </c:pt>
                <c:pt idx="37">
                  <c:v>3.0011708436065581</c:v>
                </c:pt>
                <c:pt idx="38">
                  <c:v>4.9554750566163013E-4</c:v>
                </c:pt>
                <c:pt idx="39">
                  <c:v>0.24808910124350889</c:v>
                </c:pt>
                <c:pt idx="40">
                  <c:v>11.297537083847088</c:v>
                </c:pt>
                <c:pt idx="41">
                  <c:v>0.51045898060472106</c:v>
                </c:pt>
                <c:pt idx="42">
                  <c:v>1.1000704127955772</c:v>
                </c:pt>
                <c:pt idx="43">
                  <c:v>6.284443367254311E-2</c:v>
                </c:pt>
                <c:pt idx="44">
                  <c:v>5.8778691637455633</c:v>
                </c:pt>
              </c:numCache>
            </c:numRef>
          </c:val>
        </c:ser>
        <c:ser>
          <c:idx val="2"/>
          <c:order val="2"/>
          <c:tx>
            <c:strRef>
              <c:f>'2684'!$S$2</c:f>
              <c:strCache>
                <c:ptCount val="1"/>
                <c:pt idx="0">
                  <c:v>G-Rex</c:v>
                </c:pt>
              </c:strCache>
            </c:strRef>
          </c:tx>
          <c:spPr>
            <a:solidFill>
              <a:srgbClr val="0000CC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4'!$P$3:$P$47</c:f>
              <c:strCache>
                <c:ptCount val="45"/>
                <c:pt idx="0">
                  <c:v>TRAV10</c:v>
                </c:pt>
                <c:pt idx="1">
                  <c:v>TRAV11</c:v>
                </c:pt>
                <c:pt idx="2">
                  <c:v>TRAV1-1</c:v>
                </c:pt>
                <c:pt idx="3">
                  <c:v>TRAV1-2</c:v>
                </c:pt>
                <c:pt idx="4">
                  <c:v>TRAV12-1</c:v>
                </c:pt>
                <c:pt idx="5">
                  <c:v>TRAV12-2</c:v>
                </c:pt>
                <c:pt idx="6">
                  <c:v>TRAV12-3</c:v>
                </c:pt>
                <c:pt idx="7">
                  <c:v>TRAV13-1</c:v>
                </c:pt>
                <c:pt idx="8">
                  <c:v>TRAV13-2</c:v>
                </c:pt>
                <c:pt idx="9">
                  <c:v>TRAV14_DV4</c:v>
                </c:pt>
                <c:pt idx="10">
                  <c:v>TRAV16</c:v>
                </c:pt>
                <c:pt idx="11">
                  <c:v>TRAV17</c:v>
                </c:pt>
                <c:pt idx="12">
                  <c:v>TRAV18</c:v>
                </c:pt>
                <c:pt idx="13">
                  <c:v>TRAV19</c:v>
                </c:pt>
                <c:pt idx="14">
                  <c:v>TRAV2</c:v>
                </c:pt>
                <c:pt idx="15">
                  <c:v>TRAV20</c:v>
                </c:pt>
                <c:pt idx="16">
                  <c:v>TRAV21</c:v>
                </c:pt>
                <c:pt idx="17">
                  <c:v>TRAV22</c:v>
                </c:pt>
                <c:pt idx="18">
                  <c:v>TRAV23_DV6</c:v>
                </c:pt>
                <c:pt idx="19">
                  <c:v>TRAV24</c:v>
                </c:pt>
                <c:pt idx="20">
                  <c:v>TRAV25</c:v>
                </c:pt>
                <c:pt idx="21">
                  <c:v>TRAV26-1</c:v>
                </c:pt>
                <c:pt idx="22">
                  <c:v>TRAV26-2</c:v>
                </c:pt>
                <c:pt idx="23">
                  <c:v>TRAV27</c:v>
                </c:pt>
                <c:pt idx="24">
                  <c:v>TRAV29_DV5</c:v>
                </c:pt>
                <c:pt idx="25">
                  <c:v>TRAV3</c:v>
                </c:pt>
                <c:pt idx="26">
                  <c:v>TRAV30</c:v>
                </c:pt>
                <c:pt idx="27">
                  <c:v>TRAV34</c:v>
                </c:pt>
                <c:pt idx="28">
                  <c:v>TRAV35</c:v>
                </c:pt>
                <c:pt idx="29">
                  <c:v>TRAV36_DV7</c:v>
                </c:pt>
                <c:pt idx="30">
                  <c:v>TRAV38-1</c:v>
                </c:pt>
                <c:pt idx="31">
                  <c:v>TRAV38-2_DV8</c:v>
                </c:pt>
                <c:pt idx="32">
                  <c:v>TRAV39</c:v>
                </c:pt>
                <c:pt idx="33">
                  <c:v>TRAV4</c:v>
                </c:pt>
                <c:pt idx="34">
                  <c:v>TRAV40</c:v>
                </c:pt>
                <c:pt idx="35">
                  <c:v>TRAV41</c:v>
                </c:pt>
                <c:pt idx="36">
                  <c:v>TRAV5</c:v>
                </c:pt>
                <c:pt idx="37">
                  <c:v>TRAV6</c:v>
                </c:pt>
                <c:pt idx="38">
                  <c:v>TRAV7</c:v>
                </c:pt>
                <c:pt idx="39">
                  <c:v>TRAV8-1</c:v>
                </c:pt>
                <c:pt idx="40">
                  <c:v>TRAV8-2</c:v>
                </c:pt>
                <c:pt idx="41">
                  <c:v>TRAV8-3</c:v>
                </c:pt>
                <c:pt idx="42">
                  <c:v>TRAV8-6</c:v>
                </c:pt>
                <c:pt idx="43">
                  <c:v>TRAV9-1</c:v>
                </c:pt>
                <c:pt idx="44">
                  <c:v>TRAV9-2</c:v>
                </c:pt>
              </c:strCache>
            </c:strRef>
          </c:cat>
          <c:val>
            <c:numRef>
              <c:f>'2684'!$S$3:$S$47</c:f>
              <c:numCache>
                <c:formatCode>General</c:formatCode>
                <c:ptCount val="45"/>
                <c:pt idx="0">
                  <c:v>0.19518082887320751</c:v>
                </c:pt>
                <c:pt idx="1">
                  <c:v>2.1630679224958349E-4</c:v>
                </c:pt>
                <c:pt idx="2">
                  <c:v>0.35784353664489427</c:v>
                </c:pt>
                <c:pt idx="3">
                  <c:v>5.2550293131754646</c:v>
                </c:pt>
                <c:pt idx="4">
                  <c:v>0.65346281938599171</c:v>
                </c:pt>
                <c:pt idx="5">
                  <c:v>3.1283009317775599</c:v>
                </c:pt>
                <c:pt idx="6">
                  <c:v>2.5956094047309186</c:v>
                </c:pt>
                <c:pt idx="7">
                  <c:v>3.6105208739659647</c:v>
                </c:pt>
                <c:pt idx="8">
                  <c:v>2.3121033023557982</c:v>
                </c:pt>
                <c:pt idx="9">
                  <c:v>3.346914996477806</c:v>
                </c:pt>
                <c:pt idx="10">
                  <c:v>2.7744230196572408</c:v>
                </c:pt>
                <c:pt idx="11">
                  <c:v>2.2535562639202444</c:v>
                </c:pt>
                <c:pt idx="12">
                  <c:v>0.25372786730876146</c:v>
                </c:pt>
                <c:pt idx="13">
                  <c:v>0.9467748296764269</c:v>
                </c:pt>
                <c:pt idx="14">
                  <c:v>2.0360958354453298</c:v>
                </c:pt>
                <c:pt idx="15">
                  <c:v>9.4058124519168054</c:v>
                </c:pt>
                <c:pt idx="16">
                  <c:v>1.6303042931851106</c:v>
                </c:pt>
                <c:pt idx="17">
                  <c:v>0.48416670331865108</c:v>
                </c:pt>
                <c:pt idx="18">
                  <c:v>1.9960069766150734</c:v>
                </c:pt>
                <c:pt idx="19">
                  <c:v>0.25228582202709754</c:v>
                </c:pt>
                <c:pt idx="20">
                  <c:v>0.93725733081744533</c:v>
                </c:pt>
                <c:pt idx="21">
                  <c:v>1.3320893289370184</c:v>
                </c:pt>
                <c:pt idx="22">
                  <c:v>0.76363507890511295</c:v>
                </c:pt>
                <c:pt idx="23">
                  <c:v>1.4699488578640862</c:v>
                </c:pt>
                <c:pt idx="24">
                  <c:v>2.5087982787747527</c:v>
                </c:pt>
                <c:pt idx="25">
                  <c:v>0.5626139666411667</c:v>
                </c:pt>
                <c:pt idx="26">
                  <c:v>0.43167625506608548</c:v>
                </c:pt>
                <c:pt idx="27">
                  <c:v>0.40860353055946319</c:v>
                </c:pt>
                <c:pt idx="28">
                  <c:v>1.3701593243729449</c:v>
                </c:pt>
                <c:pt idx="29">
                  <c:v>4.9005745829424798</c:v>
                </c:pt>
                <c:pt idx="30">
                  <c:v>0.49801033802262451</c:v>
                </c:pt>
                <c:pt idx="31">
                  <c:v>1.0361816371395882</c:v>
                </c:pt>
                <c:pt idx="32">
                  <c:v>1.0105132311259708</c:v>
                </c:pt>
                <c:pt idx="33">
                  <c:v>0.71835485706086677</c:v>
                </c:pt>
                <c:pt idx="34">
                  <c:v>0.12625106440967354</c:v>
                </c:pt>
                <c:pt idx="35">
                  <c:v>0.67047895370962562</c:v>
                </c:pt>
                <c:pt idx="36">
                  <c:v>0.4155253479114499</c:v>
                </c:pt>
                <c:pt idx="37">
                  <c:v>1.6346304290301026</c:v>
                </c:pt>
                <c:pt idx="38">
                  <c:v>2.8119882992445853E-3</c:v>
                </c:pt>
                <c:pt idx="39">
                  <c:v>0.33390558496927375</c:v>
                </c:pt>
                <c:pt idx="40">
                  <c:v>21.482653276795556</c:v>
                </c:pt>
                <c:pt idx="41">
                  <c:v>0.53521510628955271</c:v>
                </c:pt>
                <c:pt idx="42">
                  <c:v>1.805368590379107</c:v>
                </c:pt>
                <c:pt idx="43">
                  <c:v>1.5790395834219595E-2</c:v>
                </c:pt>
                <c:pt idx="44">
                  <c:v>11.5406162868920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11499424"/>
        <c:axId val="911499984"/>
      </c:barChart>
      <c:catAx>
        <c:axId val="9114994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 b="1"/>
            </a:pPr>
            <a:endParaRPr lang="en-US"/>
          </a:p>
        </c:txPr>
        <c:crossAx val="911499984"/>
        <c:crosses val="autoZero"/>
        <c:auto val="1"/>
        <c:lblAlgn val="ctr"/>
        <c:lblOffset val="100"/>
        <c:noMultiLvlLbl val="0"/>
      </c:catAx>
      <c:valAx>
        <c:axId val="911499984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114994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670215035090449"/>
          <c:y val="6.8773947718701781E-2"/>
          <c:w val="9.4968090166750355E-2"/>
          <c:h val="0.21242773096107223"/>
        </c:manualLayout>
      </c:layout>
      <c:overlay val="0"/>
      <c:txPr>
        <a:bodyPr/>
        <a:lstStyle/>
        <a:p>
          <a:pPr>
            <a:defRPr sz="800" b="1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7189229537278282E-2"/>
          <c:y val="3.7248511422963732E-2"/>
          <c:w val="0.96281077046272168"/>
          <c:h val="0.724645396130069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684'!$Q$50</c:f>
              <c:strCache>
                <c:ptCount val="1"/>
                <c:pt idx="0">
                  <c:v>Pre-REP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2684'!$P$51:$P$96</c:f>
              <c:strCache>
                <c:ptCount val="46"/>
                <c:pt idx="0">
                  <c:v>TRBV10-1</c:v>
                </c:pt>
                <c:pt idx="1">
                  <c:v>TRBV10-2</c:v>
                </c:pt>
                <c:pt idx="2">
                  <c:v>TRBV10-3</c:v>
                </c:pt>
                <c:pt idx="3">
                  <c:v>TRBV11-1</c:v>
                </c:pt>
                <c:pt idx="4">
                  <c:v>TRBV11-2</c:v>
                </c:pt>
                <c:pt idx="5">
                  <c:v>TRBV11-3</c:v>
                </c:pt>
                <c:pt idx="6">
                  <c:v>TRBV12-3</c:v>
                </c:pt>
                <c:pt idx="7">
                  <c:v>TRBV12-5</c:v>
                </c:pt>
                <c:pt idx="8">
                  <c:v>TRBV13</c:v>
                </c:pt>
                <c:pt idx="9">
                  <c:v>TRBV14</c:v>
                </c:pt>
                <c:pt idx="10">
                  <c:v>TRBV15</c:v>
                </c:pt>
                <c:pt idx="11">
                  <c:v>TRBV16</c:v>
                </c:pt>
                <c:pt idx="12">
                  <c:v>TRBV18</c:v>
                </c:pt>
                <c:pt idx="13">
                  <c:v>TRBV19</c:v>
                </c:pt>
                <c:pt idx="14">
                  <c:v>TRBV2</c:v>
                </c:pt>
                <c:pt idx="15">
                  <c:v>TRBV20-1</c:v>
                </c:pt>
                <c:pt idx="16">
                  <c:v>TRBV24-1</c:v>
                </c:pt>
                <c:pt idx="17">
                  <c:v>TRBV25-1</c:v>
                </c:pt>
                <c:pt idx="18">
                  <c:v>TRBV27</c:v>
                </c:pt>
                <c:pt idx="19">
                  <c:v>TRBV28</c:v>
                </c:pt>
                <c:pt idx="20">
                  <c:v>TRBV29-1</c:v>
                </c:pt>
                <c:pt idx="21">
                  <c:v>TRBV30</c:v>
                </c:pt>
                <c:pt idx="22">
                  <c:v>TRBV3-1</c:v>
                </c:pt>
                <c:pt idx="23">
                  <c:v>TRBV4-1</c:v>
                </c:pt>
                <c:pt idx="24">
                  <c:v>TRBV4-2</c:v>
                </c:pt>
                <c:pt idx="25">
                  <c:v>TRBV4-3</c:v>
                </c:pt>
                <c:pt idx="26">
                  <c:v>TRBV5-1</c:v>
                </c:pt>
                <c:pt idx="27">
                  <c:v>TRBV5-4</c:v>
                </c:pt>
                <c:pt idx="28">
                  <c:v>TRBV5-5</c:v>
                </c:pt>
                <c:pt idx="29">
                  <c:v>TRBV5-6</c:v>
                </c:pt>
                <c:pt idx="30">
                  <c:v>TRBV5-8</c:v>
                </c:pt>
                <c:pt idx="31">
                  <c:v>TRBV6-1</c:v>
                </c:pt>
                <c:pt idx="32">
                  <c:v>TRBV6-2</c:v>
                </c:pt>
                <c:pt idx="33">
                  <c:v>TRBV6-4</c:v>
                </c:pt>
                <c:pt idx="34">
                  <c:v>TRBV6-5</c:v>
                </c:pt>
                <c:pt idx="35">
                  <c:v>TRBV6-6</c:v>
                </c:pt>
                <c:pt idx="36">
                  <c:v>TRBV6-8</c:v>
                </c:pt>
                <c:pt idx="37">
                  <c:v>TRBV6-9</c:v>
                </c:pt>
                <c:pt idx="38">
                  <c:v>TRBV7-2</c:v>
                </c:pt>
                <c:pt idx="39">
                  <c:v>TRBV7-3</c:v>
                </c:pt>
                <c:pt idx="40">
                  <c:v>TRBV7-4</c:v>
                </c:pt>
                <c:pt idx="41">
                  <c:v>TRBV7-6</c:v>
                </c:pt>
                <c:pt idx="42">
                  <c:v>TRBV7-7</c:v>
                </c:pt>
                <c:pt idx="43">
                  <c:v>TRBV7-8</c:v>
                </c:pt>
                <c:pt idx="44">
                  <c:v>TRBV7-9</c:v>
                </c:pt>
                <c:pt idx="45">
                  <c:v>TRBV9</c:v>
                </c:pt>
              </c:strCache>
            </c:strRef>
          </c:cat>
          <c:val>
            <c:numRef>
              <c:f>'2684'!$Q$51:$Q$96</c:f>
              <c:numCache>
                <c:formatCode>General</c:formatCode>
                <c:ptCount val="46"/>
                <c:pt idx="0">
                  <c:v>-6.9193584561718317E-3</c:v>
                </c:pt>
                <c:pt idx="1">
                  <c:v>5.4161874812103647E-2</c:v>
                </c:pt>
                <c:pt idx="2">
                  <c:v>5.3207480542286835E-2</c:v>
                </c:pt>
                <c:pt idx="3">
                  <c:v>1.5986104019431468E-2</c:v>
                </c:pt>
                <c:pt idx="4">
                  <c:v>0.12765023358799757</c:v>
                </c:pt>
                <c:pt idx="5">
                  <c:v>3.6982777955401162E-2</c:v>
                </c:pt>
                <c:pt idx="6">
                  <c:v>0.28703407664740388</c:v>
                </c:pt>
                <c:pt idx="7">
                  <c:v>1.6701899721794076E-3</c:v>
                </c:pt>
                <c:pt idx="8">
                  <c:v>3.4119595145950754E-2</c:v>
                </c:pt>
                <c:pt idx="9">
                  <c:v>1.1214132670347449E-2</c:v>
                </c:pt>
                <c:pt idx="10">
                  <c:v>1.7894892559065078E-2</c:v>
                </c:pt>
                <c:pt idx="11">
                  <c:v>1.503170974961467E-2</c:v>
                </c:pt>
                <c:pt idx="12">
                  <c:v>9.1383251334959004E-2</c:v>
                </c:pt>
                <c:pt idx="13">
                  <c:v>0.10474477111239427</c:v>
                </c:pt>
                <c:pt idx="14">
                  <c:v>49.865907605090754</c:v>
                </c:pt>
                <c:pt idx="15">
                  <c:v>0.58385069456043004</c:v>
                </c:pt>
                <c:pt idx="16">
                  <c:v>5.225308627247003E-2</c:v>
                </c:pt>
                <c:pt idx="17">
                  <c:v>5.4877670514466249E-3</c:v>
                </c:pt>
                <c:pt idx="18">
                  <c:v>7.5158548748073331E-2</c:v>
                </c:pt>
                <c:pt idx="19">
                  <c:v>1.523929050329982</c:v>
                </c:pt>
                <c:pt idx="20">
                  <c:v>9.3292039874592614E-2</c:v>
                </c:pt>
                <c:pt idx="21">
                  <c:v>6.370581751027167E-2</c:v>
                </c:pt>
                <c:pt idx="22">
                  <c:v>5.3271902155499467</c:v>
                </c:pt>
                <c:pt idx="23">
                  <c:v>7.9930520097157357E-2</c:v>
                </c:pt>
                <c:pt idx="24">
                  <c:v>1.4077315479797863E-2</c:v>
                </c:pt>
                <c:pt idx="25">
                  <c:v>6.1797028970638074E-2</c:v>
                </c:pt>
                <c:pt idx="26">
                  <c:v>3.5073989415767559E-2</c:v>
                </c:pt>
                <c:pt idx="27">
                  <c:v>1.2168526940164254E-2</c:v>
                </c:pt>
                <c:pt idx="28">
                  <c:v>6.6569000319722085E-2</c:v>
                </c:pt>
                <c:pt idx="29">
                  <c:v>9.3053441307138426E-3</c:v>
                </c:pt>
                <c:pt idx="30">
                  <c:v>2.0758075368515493E-2</c:v>
                </c:pt>
                <c:pt idx="31">
                  <c:v>2.0758075368515493E-2</c:v>
                </c:pt>
                <c:pt idx="32">
                  <c:v>1.9803681098698688E-2</c:v>
                </c:pt>
                <c:pt idx="33">
                  <c:v>2.6484440987416317E-2</c:v>
                </c:pt>
                <c:pt idx="34">
                  <c:v>5.7025057621554055E-2</c:v>
                </c:pt>
                <c:pt idx="35">
                  <c:v>4.2709143574301986E-2</c:v>
                </c:pt>
                <c:pt idx="36">
                  <c:v>2.6245842419962118E-3</c:v>
                </c:pt>
                <c:pt idx="37">
                  <c:v>0.17155236999957058</c:v>
                </c:pt>
                <c:pt idx="38">
                  <c:v>0.4826849019598487</c:v>
                </c:pt>
                <c:pt idx="39">
                  <c:v>5.4877670514466249E-3</c:v>
                </c:pt>
                <c:pt idx="40">
                  <c:v>1.6701899721794076E-3</c:v>
                </c:pt>
                <c:pt idx="41">
                  <c:v>5.6879512495406992</c:v>
                </c:pt>
                <c:pt idx="42">
                  <c:v>8.0884914366974162E-2</c:v>
                </c:pt>
                <c:pt idx="43">
                  <c:v>34.288284333140872</c:v>
                </c:pt>
                <c:pt idx="44">
                  <c:v>0.19922980382425792</c:v>
                </c:pt>
                <c:pt idx="45">
                  <c:v>0.17823312988828821</c:v>
                </c:pt>
              </c:numCache>
            </c:numRef>
          </c:val>
        </c:ser>
        <c:ser>
          <c:idx val="1"/>
          <c:order val="1"/>
          <c:tx>
            <c:strRef>
              <c:f>'2684'!$R$50</c:f>
              <c:strCache>
                <c:ptCount val="1"/>
                <c:pt idx="0">
                  <c:v>Bag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4'!$P$51:$P$96</c:f>
              <c:strCache>
                <c:ptCount val="46"/>
                <c:pt idx="0">
                  <c:v>TRBV10-1</c:v>
                </c:pt>
                <c:pt idx="1">
                  <c:v>TRBV10-2</c:v>
                </c:pt>
                <c:pt idx="2">
                  <c:v>TRBV10-3</c:v>
                </c:pt>
                <c:pt idx="3">
                  <c:v>TRBV11-1</c:v>
                </c:pt>
                <c:pt idx="4">
                  <c:v>TRBV11-2</c:v>
                </c:pt>
                <c:pt idx="5">
                  <c:v>TRBV11-3</c:v>
                </c:pt>
                <c:pt idx="6">
                  <c:v>TRBV12-3</c:v>
                </c:pt>
                <c:pt idx="7">
                  <c:v>TRBV12-5</c:v>
                </c:pt>
                <c:pt idx="8">
                  <c:v>TRBV13</c:v>
                </c:pt>
                <c:pt idx="9">
                  <c:v>TRBV14</c:v>
                </c:pt>
                <c:pt idx="10">
                  <c:v>TRBV15</c:v>
                </c:pt>
                <c:pt idx="11">
                  <c:v>TRBV16</c:v>
                </c:pt>
                <c:pt idx="12">
                  <c:v>TRBV18</c:v>
                </c:pt>
                <c:pt idx="13">
                  <c:v>TRBV19</c:v>
                </c:pt>
                <c:pt idx="14">
                  <c:v>TRBV2</c:v>
                </c:pt>
                <c:pt idx="15">
                  <c:v>TRBV20-1</c:v>
                </c:pt>
                <c:pt idx="16">
                  <c:v>TRBV24-1</c:v>
                </c:pt>
                <c:pt idx="17">
                  <c:v>TRBV25-1</c:v>
                </c:pt>
                <c:pt idx="18">
                  <c:v>TRBV27</c:v>
                </c:pt>
                <c:pt idx="19">
                  <c:v>TRBV28</c:v>
                </c:pt>
                <c:pt idx="20">
                  <c:v>TRBV29-1</c:v>
                </c:pt>
                <c:pt idx="21">
                  <c:v>TRBV30</c:v>
                </c:pt>
                <c:pt idx="22">
                  <c:v>TRBV3-1</c:v>
                </c:pt>
                <c:pt idx="23">
                  <c:v>TRBV4-1</c:v>
                </c:pt>
                <c:pt idx="24">
                  <c:v>TRBV4-2</c:v>
                </c:pt>
                <c:pt idx="25">
                  <c:v>TRBV4-3</c:v>
                </c:pt>
                <c:pt idx="26">
                  <c:v>TRBV5-1</c:v>
                </c:pt>
                <c:pt idx="27">
                  <c:v>TRBV5-4</c:v>
                </c:pt>
                <c:pt idx="28">
                  <c:v>TRBV5-5</c:v>
                </c:pt>
                <c:pt idx="29">
                  <c:v>TRBV5-6</c:v>
                </c:pt>
                <c:pt idx="30">
                  <c:v>TRBV5-8</c:v>
                </c:pt>
                <c:pt idx="31">
                  <c:v>TRBV6-1</c:v>
                </c:pt>
                <c:pt idx="32">
                  <c:v>TRBV6-2</c:v>
                </c:pt>
                <c:pt idx="33">
                  <c:v>TRBV6-4</c:v>
                </c:pt>
                <c:pt idx="34">
                  <c:v>TRBV6-5</c:v>
                </c:pt>
                <c:pt idx="35">
                  <c:v>TRBV6-6</c:v>
                </c:pt>
                <c:pt idx="36">
                  <c:v>TRBV6-8</c:v>
                </c:pt>
                <c:pt idx="37">
                  <c:v>TRBV6-9</c:v>
                </c:pt>
                <c:pt idx="38">
                  <c:v>TRBV7-2</c:v>
                </c:pt>
                <c:pt idx="39">
                  <c:v>TRBV7-3</c:v>
                </c:pt>
                <c:pt idx="40">
                  <c:v>TRBV7-4</c:v>
                </c:pt>
                <c:pt idx="41">
                  <c:v>TRBV7-6</c:v>
                </c:pt>
                <c:pt idx="42">
                  <c:v>TRBV7-7</c:v>
                </c:pt>
                <c:pt idx="43">
                  <c:v>TRBV7-8</c:v>
                </c:pt>
                <c:pt idx="44">
                  <c:v>TRBV7-9</c:v>
                </c:pt>
                <c:pt idx="45">
                  <c:v>TRBV9</c:v>
                </c:pt>
              </c:strCache>
            </c:strRef>
          </c:cat>
          <c:val>
            <c:numRef>
              <c:f>'2684'!$R$51:$R$96</c:f>
              <c:numCache>
                <c:formatCode>General</c:formatCode>
                <c:ptCount val="46"/>
                <c:pt idx="0">
                  <c:v>2.196796721681895E-2</c:v>
                </c:pt>
                <c:pt idx="1">
                  <c:v>0.2272812862209935</c:v>
                </c:pt>
                <c:pt idx="2">
                  <c:v>2.5437511245507021</c:v>
                </c:pt>
                <c:pt idx="3">
                  <c:v>7.1622547084676372E-2</c:v>
                </c:pt>
                <c:pt idx="4">
                  <c:v>6.7973074943545795</c:v>
                </c:pt>
                <c:pt idx="5">
                  <c:v>0.2507137845856004</c:v>
                </c:pt>
                <c:pt idx="6">
                  <c:v>1.4028116208454389</c:v>
                </c:pt>
                <c:pt idx="7">
                  <c:v>0.11904546044161889</c:v>
                </c:pt>
                <c:pt idx="8">
                  <c:v>0.23732378552011071</c:v>
                </c:pt>
                <c:pt idx="9">
                  <c:v>0.42534168906469444</c:v>
                </c:pt>
                <c:pt idx="10">
                  <c:v>0.70541583618451953</c:v>
                </c:pt>
                <c:pt idx="11">
                  <c:v>0.1179296271861614</c:v>
                </c:pt>
                <c:pt idx="12">
                  <c:v>6.6544808376560223</c:v>
                </c:pt>
                <c:pt idx="13">
                  <c:v>8.9017690141473693</c:v>
                </c:pt>
                <c:pt idx="14">
                  <c:v>3.9681122751421634</c:v>
                </c:pt>
                <c:pt idx="15">
                  <c:v>9.6075335482242181</c:v>
                </c:pt>
                <c:pt idx="16">
                  <c:v>0.78631374720518621</c:v>
                </c:pt>
                <c:pt idx="17">
                  <c:v>9.1707545682910854E-2</c:v>
                </c:pt>
                <c:pt idx="18">
                  <c:v>3.7494089570724984</c:v>
                </c:pt>
                <c:pt idx="19">
                  <c:v>1.7264032649281051</c:v>
                </c:pt>
                <c:pt idx="20">
                  <c:v>2.7624544426203665</c:v>
                </c:pt>
                <c:pt idx="21">
                  <c:v>0.33607502862809685</c:v>
                </c:pt>
                <c:pt idx="22">
                  <c:v>5.7562350670127591</c:v>
                </c:pt>
                <c:pt idx="23">
                  <c:v>1.4864991150047488</c:v>
                </c:pt>
                <c:pt idx="24">
                  <c:v>0.77124999825651031</c:v>
                </c:pt>
                <c:pt idx="25">
                  <c:v>0.55979959634731968</c:v>
                </c:pt>
                <c:pt idx="26">
                  <c:v>0.79970374627067586</c:v>
                </c:pt>
                <c:pt idx="27">
                  <c:v>0.29534711480389919</c:v>
                </c:pt>
                <c:pt idx="28">
                  <c:v>0.22672336959326475</c:v>
                </c:pt>
                <c:pt idx="29">
                  <c:v>0.29534711480389919</c:v>
                </c:pt>
                <c:pt idx="30">
                  <c:v>2.5873383610920096E-2</c:v>
                </c:pt>
                <c:pt idx="31">
                  <c:v>3.0163065082369411</c:v>
                </c:pt>
                <c:pt idx="32">
                  <c:v>0.58992709424467138</c:v>
                </c:pt>
                <c:pt idx="33">
                  <c:v>1.0764303936241284</c:v>
                </c:pt>
                <c:pt idx="34">
                  <c:v>3.0347177569519888</c:v>
                </c:pt>
                <c:pt idx="35">
                  <c:v>4.4094243276755929</c:v>
                </c:pt>
                <c:pt idx="36">
                  <c:v>8.7244212661080969E-2</c:v>
                </c:pt>
                <c:pt idx="37">
                  <c:v>3.5217789729591749</c:v>
                </c:pt>
                <c:pt idx="38">
                  <c:v>1.5043524470920686</c:v>
                </c:pt>
                <c:pt idx="39">
                  <c:v>7.441213022332005E-2</c:v>
                </c:pt>
                <c:pt idx="40">
                  <c:v>6.4927547551931544E-2</c:v>
                </c:pt>
                <c:pt idx="41">
                  <c:v>2.2056536481470888</c:v>
                </c:pt>
                <c:pt idx="42">
                  <c:v>0.23286045249828086</c:v>
                </c:pt>
                <c:pt idx="43">
                  <c:v>12.070735459646585</c:v>
                </c:pt>
                <c:pt idx="44">
                  <c:v>4.0886222667315693</c:v>
                </c:pt>
                <c:pt idx="45">
                  <c:v>2.3010573914887025</c:v>
                </c:pt>
              </c:numCache>
            </c:numRef>
          </c:val>
        </c:ser>
        <c:ser>
          <c:idx val="2"/>
          <c:order val="2"/>
          <c:tx>
            <c:strRef>
              <c:f>'2684'!$S$50</c:f>
              <c:strCache>
                <c:ptCount val="1"/>
                <c:pt idx="0">
                  <c:v>G-Rex</c:v>
                </c:pt>
              </c:strCache>
            </c:strRef>
          </c:tx>
          <c:spPr>
            <a:solidFill>
              <a:srgbClr val="0000CC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4'!$P$51:$P$96</c:f>
              <c:strCache>
                <c:ptCount val="46"/>
                <c:pt idx="0">
                  <c:v>TRBV10-1</c:v>
                </c:pt>
                <c:pt idx="1">
                  <c:v>TRBV10-2</c:v>
                </c:pt>
                <c:pt idx="2">
                  <c:v>TRBV10-3</c:v>
                </c:pt>
                <c:pt idx="3">
                  <c:v>TRBV11-1</c:v>
                </c:pt>
                <c:pt idx="4">
                  <c:v>TRBV11-2</c:v>
                </c:pt>
                <c:pt idx="5">
                  <c:v>TRBV11-3</c:v>
                </c:pt>
                <c:pt idx="6">
                  <c:v>TRBV12-3</c:v>
                </c:pt>
                <c:pt idx="7">
                  <c:v>TRBV12-5</c:v>
                </c:pt>
                <c:pt idx="8">
                  <c:v>TRBV13</c:v>
                </c:pt>
                <c:pt idx="9">
                  <c:v>TRBV14</c:v>
                </c:pt>
                <c:pt idx="10">
                  <c:v>TRBV15</c:v>
                </c:pt>
                <c:pt idx="11">
                  <c:v>TRBV16</c:v>
                </c:pt>
                <c:pt idx="12">
                  <c:v>TRBV18</c:v>
                </c:pt>
                <c:pt idx="13">
                  <c:v>TRBV19</c:v>
                </c:pt>
                <c:pt idx="14">
                  <c:v>TRBV2</c:v>
                </c:pt>
                <c:pt idx="15">
                  <c:v>TRBV20-1</c:v>
                </c:pt>
                <c:pt idx="16">
                  <c:v>TRBV24-1</c:v>
                </c:pt>
                <c:pt idx="17">
                  <c:v>TRBV25-1</c:v>
                </c:pt>
                <c:pt idx="18">
                  <c:v>TRBV27</c:v>
                </c:pt>
                <c:pt idx="19">
                  <c:v>TRBV28</c:v>
                </c:pt>
                <c:pt idx="20">
                  <c:v>TRBV29-1</c:v>
                </c:pt>
                <c:pt idx="21">
                  <c:v>TRBV30</c:v>
                </c:pt>
                <c:pt idx="22">
                  <c:v>TRBV3-1</c:v>
                </c:pt>
                <c:pt idx="23">
                  <c:v>TRBV4-1</c:v>
                </c:pt>
                <c:pt idx="24">
                  <c:v>TRBV4-2</c:v>
                </c:pt>
                <c:pt idx="25">
                  <c:v>TRBV4-3</c:v>
                </c:pt>
                <c:pt idx="26">
                  <c:v>TRBV5-1</c:v>
                </c:pt>
                <c:pt idx="27">
                  <c:v>TRBV5-4</c:v>
                </c:pt>
                <c:pt idx="28">
                  <c:v>TRBV5-5</c:v>
                </c:pt>
                <c:pt idx="29">
                  <c:v>TRBV5-6</c:v>
                </c:pt>
                <c:pt idx="30">
                  <c:v>TRBV5-8</c:v>
                </c:pt>
                <c:pt idx="31">
                  <c:v>TRBV6-1</c:v>
                </c:pt>
                <c:pt idx="32">
                  <c:v>TRBV6-2</c:v>
                </c:pt>
                <c:pt idx="33">
                  <c:v>TRBV6-4</c:v>
                </c:pt>
                <c:pt idx="34">
                  <c:v>TRBV6-5</c:v>
                </c:pt>
                <c:pt idx="35">
                  <c:v>TRBV6-6</c:v>
                </c:pt>
                <c:pt idx="36">
                  <c:v>TRBV6-8</c:v>
                </c:pt>
                <c:pt idx="37">
                  <c:v>TRBV6-9</c:v>
                </c:pt>
                <c:pt idx="38">
                  <c:v>TRBV7-2</c:v>
                </c:pt>
                <c:pt idx="39">
                  <c:v>TRBV7-3</c:v>
                </c:pt>
                <c:pt idx="40">
                  <c:v>TRBV7-4</c:v>
                </c:pt>
                <c:pt idx="41">
                  <c:v>TRBV7-6</c:v>
                </c:pt>
                <c:pt idx="42">
                  <c:v>TRBV7-7</c:v>
                </c:pt>
                <c:pt idx="43">
                  <c:v>TRBV7-8</c:v>
                </c:pt>
                <c:pt idx="44">
                  <c:v>TRBV7-9</c:v>
                </c:pt>
                <c:pt idx="45">
                  <c:v>TRBV9</c:v>
                </c:pt>
              </c:strCache>
            </c:strRef>
          </c:cat>
          <c:val>
            <c:numRef>
              <c:f>'2684'!$S$51:$S$96</c:f>
              <c:numCache>
                <c:formatCode>General</c:formatCode>
                <c:ptCount val="46"/>
                <c:pt idx="0">
                  <c:v>1.7602479103643816E-2</c:v>
                </c:pt>
                <c:pt idx="1">
                  <c:v>0.20311363612408162</c:v>
                </c:pt>
                <c:pt idx="2">
                  <c:v>1.5050646653947906</c:v>
                </c:pt>
                <c:pt idx="3">
                  <c:v>0.14493059142221706</c:v>
                </c:pt>
                <c:pt idx="4">
                  <c:v>4.8990756063368917</c:v>
                </c:pt>
                <c:pt idx="5">
                  <c:v>0.59100060080317895</c:v>
                </c:pt>
                <c:pt idx="6">
                  <c:v>2.0379876255625939</c:v>
                </c:pt>
                <c:pt idx="7">
                  <c:v>0.34224700388940998</c:v>
                </c:pt>
                <c:pt idx="8">
                  <c:v>0.38061408409136416</c:v>
                </c:pt>
                <c:pt idx="9">
                  <c:v>0.29755567969812274</c:v>
                </c:pt>
                <c:pt idx="10">
                  <c:v>1.2019225701727572</c:v>
                </c:pt>
                <c:pt idx="11">
                  <c:v>0.11963361546488463</c:v>
                </c:pt>
                <c:pt idx="12">
                  <c:v>3.5916435656087606</c:v>
                </c:pt>
                <c:pt idx="13">
                  <c:v>6.507120044691324</c:v>
                </c:pt>
                <c:pt idx="14">
                  <c:v>5.9729322357256542</c:v>
                </c:pt>
                <c:pt idx="15">
                  <c:v>6.0180451761828966</c:v>
                </c:pt>
                <c:pt idx="16">
                  <c:v>0.85957016221685834</c:v>
                </c:pt>
                <c:pt idx="17">
                  <c:v>0.22166475182612541</c:v>
                </c:pt>
                <c:pt idx="18">
                  <c:v>1.2196304533428899</c:v>
                </c:pt>
                <c:pt idx="19">
                  <c:v>1.6661220789898075</c:v>
                </c:pt>
                <c:pt idx="20">
                  <c:v>2.6463798973364385</c:v>
                </c:pt>
                <c:pt idx="21">
                  <c:v>0.58804928694149017</c:v>
                </c:pt>
                <c:pt idx="22">
                  <c:v>8.6792870468942684</c:v>
                </c:pt>
                <c:pt idx="23">
                  <c:v>1.400925447703772</c:v>
                </c:pt>
                <c:pt idx="24">
                  <c:v>0.21534050783679229</c:v>
                </c:pt>
                <c:pt idx="25">
                  <c:v>0.67996163291979794</c:v>
                </c:pt>
                <c:pt idx="26">
                  <c:v>0.66604829614326522</c:v>
                </c:pt>
                <c:pt idx="27">
                  <c:v>0.23389162353883611</c:v>
                </c:pt>
                <c:pt idx="28">
                  <c:v>0.3721817587722534</c:v>
                </c:pt>
                <c:pt idx="29">
                  <c:v>0.17191403244337164</c:v>
                </c:pt>
                <c:pt idx="30">
                  <c:v>3.1937432146132198E-2</c:v>
                </c:pt>
                <c:pt idx="31">
                  <c:v>1.0113520179608528</c:v>
                </c:pt>
                <c:pt idx="32">
                  <c:v>0.82204631454681509</c:v>
                </c:pt>
                <c:pt idx="33">
                  <c:v>0.71073962033455251</c:v>
                </c:pt>
                <c:pt idx="34">
                  <c:v>1.9190918385631317</c:v>
                </c:pt>
                <c:pt idx="35">
                  <c:v>1.7601425062978928</c:v>
                </c:pt>
                <c:pt idx="36">
                  <c:v>1.3807932710043953E-2</c:v>
                </c:pt>
                <c:pt idx="37">
                  <c:v>2.1062894606473916</c:v>
                </c:pt>
                <c:pt idx="38">
                  <c:v>1.8301308064465127</c:v>
                </c:pt>
                <c:pt idx="39">
                  <c:v>3.1094199614221111E-2</c:v>
                </c:pt>
                <c:pt idx="40">
                  <c:v>5.133178038008706E-2</c:v>
                </c:pt>
                <c:pt idx="41">
                  <c:v>4.830773771252094</c:v>
                </c:pt>
                <c:pt idx="42">
                  <c:v>0.1369198823690618</c:v>
                </c:pt>
                <c:pt idx="43">
                  <c:v>25.675060343828061</c:v>
                </c:pt>
                <c:pt idx="44">
                  <c:v>3.5292443582473401</c:v>
                </c:pt>
                <c:pt idx="45">
                  <c:v>2.088581577477258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82157648"/>
        <c:axId val="282158208"/>
      </c:barChart>
      <c:catAx>
        <c:axId val="28215764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 b="1"/>
            </a:pPr>
            <a:endParaRPr lang="en-US"/>
          </a:p>
        </c:txPr>
        <c:crossAx val="282158208"/>
        <c:crosses val="autoZero"/>
        <c:auto val="1"/>
        <c:lblAlgn val="ctr"/>
        <c:lblOffset val="100"/>
        <c:noMultiLvlLbl val="0"/>
      </c:catAx>
      <c:valAx>
        <c:axId val="282158208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821576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3.1480647788881787E-2"/>
          <c:y val="2.4767649123737422E-2"/>
          <c:w val="0.96322820047938951"/>
          <c:h val="0.693522233627060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686'!$Q$2</c:f>
              <c:strCache>
                <c:ptCount val="1"/>
                <c:pt idx="0">
                  <c:v>Pre-REP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6'!$P$3:$P$47</c:f>
              <c:strCache>
                <c:ptCount val="45"/>
                <c:pt idx="0">
                  <c:v>TRAV10</c:v>
                </c:pt>
                <c:pt idx="1">
                  <c:v>TRAV11</c:v>
                </c:pt>
                <c:pt idx="2">
                  <c:v>TRAV1-1</c:v>
                </c:pt>
                <c:pt idx="3">
                  <c:v>TRAV1-2</c:v>
                </c:pt>
                <c:pt idx="4">
                  <c:v>TRAV12-1</c:v>
                </c:pt>
                <c:pt idx="5">
                  <c:v>TRAV12-2</c:v>
                </c:pt>
                <c:pt idx="6">
                  <c:v>TRAV12-3</c:v>
                </c:pt>
                <c:pt idx="7">
                  <c:v>TRAV13-1</c:v>
                </c:pt>
                <c:pt idx="8">
                  <c:v>TRAV13-2</c:v>
                </c:pt>
                <c:pt idx="9">
                  <c:v>TRAV14_DV4</c:v>
                </c:pt>
                <c:pt idx="10">
                  <c:v>TRAV16</c:v>
                </c:pt>
                <c:pt idx="11">
                  <c:v>TRAV17</c:v>
                </c:pt>
                <c:pt idx="12">
                  <c:v>TRAV18</c:v>
                </c:pt>
                <c:pt idx="13">
                  <c:v>TRAV19</c:v>
                </c:pt>
                <c:pt idx="14">
                  <c:v>TRAV2</c:v>
                </c:pt>
                <c:pt idx="15">
                  <c:v>TRAV20</c:v>
                </c:pt>
                <c:pt idx="16">
                  <c:v>TRAV21</c:v>
                </c:pt>
                <c:pt idx="17">
                  <c:v>TRAV22</c:v>
                </c:pt>
                <c:pt idx="18">
                  <c:v>TRAV23_DV6</c:v>
                </c:pt>
                <c:pt idx="19">
                  <c:v>TRAV24</c:v>
                </c:pt>
                <c:pt idx="20">
                  <c:v>TRAV25</c:v>
                </c:pt>
                <c:pt idx="21">
                  <c:v>TRAV26-1</c:v>
                </c:pt>
                <c:pt idx="22">
                  <c:v>TRAV26-2</c:v>
                </c:pt>
                <c:pt idx="23">
                  <c:v>TRAV27</c:v>
                </c:pt>
                <c:pt idx="24">
                  <c:v>TRAV29_DV5</c:v>
                </c:pt>
                <c:pt idx="25">
                  <c:v>TRAV3</c:v>
                </c:pt>
                <c:pt idx="26">
                  <c:v>TRAV30</c:v>
                </c:pt>
                <c:pt idx="27">
                  <c:v>TRAV34</c:v>
                </c:pt>
                <c:pt idx="28">
                  <c:v>TRAV35</c:v>
                </c:pt>
                <c:pt idx="29">
                  <c:v>TRAV36_DV7</c:v>
                </c:pt>
                <c:pt idx="30">
                  <c:v>TRAV38-1</c:v>
                </c:pt>
                <c:pt idx="31">
                  <c:v>TRAV38-2_DV8</c:v>
                </c:pt>
                <c:pt idx="32">
                  <c:v>TRAV39</c:v>
                </c:pt>
                <c:pt idx="33">
                  <c:v>TRAV4</c:v>
                </c:pt>
                <c:pt idx="34">
                  <c:v>TRAV40</c:v>
                </c:pt>
                <c:pt idx="35">
                  <c:v>TRAV41</c:v>
                </c:pt>
                <c:pt idx="36">
                  <c:v>TRAV5</c:v>
                </c:pt>
                <c:pt idx="37">
                  <c:v>TRAV6</c:v>
                </c:pt>
                <c:pt idx="38">
                  <c:v>TRAV7</c:v>
                </c:pt>
                <c:pt idx="39">
                  <c:v>TRAV8-1</c:v>
                </c:pt>
                <c:pt idx="40">
                  <c:v>TRAV8-2</c:v>
                </c:pt>
                <c:pt idx="41">
                  <c:v>TRAV8-3</c:v>
                </c:pt>
                <c:pt idx="42">
                  <c:v>TRAV8-6</c:v>
                </c:pt>
                <c:pt idx="43">
                  <c:v>TRAV9-1</c:v>
                </c:pt>
                <c:pt idx="44">
                  <c:v>TRAV9-2</c:v>
                </c:pt>
              </c:strCache>
            </c:strRef>
          </c:cat>
          <c:val>
            <c:numRef>
              <c:f>'2686'!$Q$3:$Q$47</c:f>
              <c:numCache>
                <c:formatCode>General</c:formatCode>
                <c:ptCount val="45"/>
                <c:pt idx="0">
                  <c:v>4.2983736753481434</c:v>
                </c:pt>
                <c:pt idx="1">
                  <c:v>-2.6594516210757344E-3</c:v>
                </c:pt>
                <c:pt idx="2">
                  <c:v>4.9969696248633531E-2</c:v>
                </c:pt>
                <c:pt idx="3">
                  <c:v>6.1885439222432348</c:v>
                </c:pt>
                <c:pt idx="4">
                  <c:v>49.950240260458301</c:v>
                </c:pt>
                <c:pt idx="5">
                  <c:v>0.36126550705244581</c:v>
                </c:pt>
                <c:pt idx="6">
                  <c:v>2.4238801959036045</c:v>
                </c:pt>
                <c:pt idx="7">
                  <c:v>7.2365078320850262E-2</c:v>
                </c:pt>
                <c:pt idx="8">
                  <c:v>4.8849927145022697E-2</c:v>
                </c:pt>
                <c:pt idx="9">
                  <c:v>4.3251081626968516E-2</c:v>
                </c:pt>
                <c:pt idx="10">
                  <c:v>0.10371861322195364</c:v>
                </c:pt>
                <c:pt idx="11">
                  <c:v>0.14850937736638706</c:v>
                </c:pt>
                <c:pt idx="12">
                  <c:v>8.3562769356958611E-2</c:v>
                </c:pt>
                <c:pt idx="13">
                  <c:v>1.3802553913383062</c:v>
                </c:pt>
                <c:pt idx="14">
                  <c:v>9.3640691289456124E-2</c:v>
                </c:pt>
                <c:pt idx="15">
                  <c:v>2.0855699554751812E-2</c:v>
                </c:pt>
                <c:pt idx="16">
                  <c:v>1.9735930451140977E-2</c:v>
                </c:pt>
                <c:pt idx="17">
                  <c:v>2.4215006865584324E-2</c:v>
                </c:pt>
                <c:pt idx="18">
                  <c:v>3.0933621487249333E-2</c:v>
                </c:pt>
                <c:pt idx="19">
                  <c:v>9.6580085186434572E-3</c:v>
                </c:pt>
                <c:pt idx="20">
                  <c:v>0.42509234595826345</c:v>
                </c:pt>
                <c:pt idx="21">
                  <c:v>2.5334775969195155E-2</c:v>
                </c:pt>
                <c:pt idx="22">
                  <c:v>1.9735930451140977E-2</c:v>
                </c:pt>
                <c:pt idx="23">
                  <c:v>8.5382394150326224E-3</c:v>
                </c:pt>
                <c:pt idx="24">
                  <c:v>4.0486651652429275</c:v>
                </c:pt>
                <c:pt idx="25">
                  <c:v>0.42957142237270679</c:v>
                </c:pt>
                <c:pt idx="26">
                  <c:v>6.9985568975677208E-4</c:v>
                </c:pt>
                <c:pt idx="27">
                  <c:v>4.0591630005892788E-3</c:v>
                </c:pt>
                <c:pt idx="28">
                  <c:v>3.6532467005303514E-2</c:v>
                </c:pt>
                <c:pt idx="29">
                  <c:v>9.3640691289456124E-2</c:v>
                </c:pt>
                <c:pt idx="30">
                  <c:v>2.4215006865584324E-2</c:v>
                </c:pt>
                <c:pt idx="31">
                  <c:v>6.11673872847419E-2</c:v>
                </c:pt>
                <c:pt idx="32">
                  <c:v>4.2131312523357688E-2</c:v>
                </c:pt>
                <c:pt idx="33">
                  <c:v>5.5670720697392202</c:v>
                </c:pt>
                <c:pt idx="34">
                  <c:v>4.0591630005892788E-3</c:v>
                </c:pt>
                <c:pt idx="35">
                  <c:v>9.6580085186434572E-3</c:v>
                </c:pt>
                <c:pt idx="36">
                  <c:v>0.36574458346688921</c:v>
                </c:pt>
                <c:pt idx="37">
                  <c:v>0.44524818982325848</c:v>
                </c:pt>
                <c:pt idx="38">
                  <c:v>9.6580085186434572E-3</c:v>
                </c:pt>
                <c:pt idx="39">
                  <c:v>1.5256854036697638E-2</c:v>
                </c:pt>
                <c:pt idx="40">
                  <c:v>10.676578489515464</c:v>
                </c:pt>
                <c:pt idx="41">
                  <c:v>12.225219159809249</c:v>
                </c:pt>
                <c:pt idx="42">
                  <c:v>3.6532467005303514E-2</c:v>
                </c:pt>
                <c:pt idx="43">
                  <c:v>5.8927849077520231E-2</c:v>
                </c:pt>
                <c:pt idx="44">
                  <c:v>1.7496392243919308E-2</c:v>
                </c:pt>
              </c:numCache>
            </c:numRef>
          </c:val>
        </c:ser>
        <c:ser>
          <c:idx val="1"/>
          <c:order val="1"/>
          <c:tx>
            <c:strRef>
              <c:f>'2686'!$R$2</c:f>
              <c:strCache>
                <c:ptCount val="1"/>
                <c:pt idx="0">
                  <c:v>Bag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6'!$P$3:$P$47</c:f>
              <c:strCache>
                <c:ptCount val="45"/>
                <c:pt idx="0">
                  <c:v>TRAV10</c:v>
                </c:pt>
                <c:pt idx="1">
                  <c:v>TRAV11</c:v>
                </c:pt>
                <c:pt idx="2">
                  <c:v>TRAV1-1</c:v>
                </c:pt>
                <c:pt idx="3">
                  <c:v>TRAV1-2</c:v>
                </c:pt>
                <c:pt idx="4">
                  <c:v>TRAV12-1</c:v>
                </c:pt>
                <c:pt idx="5">
                  <c:v>TRAV12-2</c:v>
                </c:pt>
                <c:pt idx="6">
                  <c:v>TRAV12-3</c:v>
                </c:pt>
                <c:pt idx="7">
                  <c:v>TRAV13-1</c:v>
                </c:pt>
                <c:pt idx="8">
                  <c:v>TRAV13-2</c:v>
                </c:pt>
                <c:pt idx="9">
                  <c:v>TRAV14_DV4</c:v>
                </c:pt>
                <c:pt idx="10">
                  <c:v>TRAV16</c:v>
                </c:pt>
                <c:pt idx="11">
                  <c:v>TRAV17</c:v>
                </c:pt>
                <c:pt idx="12">
                  <c:v>TRAV18</c:v>
                </c:pt>
                <c:pt idx="13">
                  <c:v>TRAV19</c:v>
                </c:pt>
                <c:pt idx="14">
                  <c:v>TRAV2</c:v>
                </c:pt>
                <c:pt idx="15">
                  <c:v>TRAV20</c:v>
                </c:pt>
                <c:pt idx="16">
                  <c:v>TRAV21</c:v>
                </c:pt>
                <c:pt idx="17">
                  <c:v>TRAV22</c:v>
                </c:pt>
                <c:pt idx="18">
                  <c:v>TRAV23_DV6</c:v>
                </c:pt>
                <c:pt idx="19">
                  <c:v>TRAV24</c:v>
                </c:pt>
                <c:pt idx="20">
                  <c:v>TRAV25</c:v>
                </c:pt>
                <c:pt idx="21">
                  <c:v>TRAV26-1</c:v>
                </c:pt>
                <c:pt idx="22">
                  <c:v>TRAV26-2</c:v>
                </c:pt>
                <c:pt idx="23">
                  <c:v>TRAV27</c:v>
                </c:pt>
                <c:pt idx="24">
                  <c:v>TRAV29_DV5</c:v>
                </c:pt>
                <c:pt idx="25">
                  <c:v>TRAV3</c:v>
                </c:pt>
                <c:pt idx="26">
                  <c:v>TRAV30</c:v>
                </c:pt>
                <c:pt idx="27">
                  <c:v>TRAV34</c:v>
                </c:pt>
                <c:pt idx="28">
                  <c:v>TRAV35</c:v>
                </c:pt>
                <c:pt idx="29">
                  <c:v>TRAV36_DV7</c:v>
                </c:pt>
                <c:pt idx="30">
                  <c:v>TRAV38-1</c:v>
                </c:pt>
                <c:pt idx="31">
                  <c:v>TRAV38-2_DV8</c:v>
                </c:pt>
                <c:pt idx="32">
                  <c:v>TRAV39</c:v>
                </c:pt>
                <c:pt idx="33">
                  <c:v>TRAV4</c:v>
                </c:pt>
                <c:pt idx="34">
                  <c:v>TRAV40</c:v>
                </c:pt>
                <c:pt idx="35">
                  <c:v>TRAV41</c:v>
                </c:pt>
                <c:pt idx="36">
                  <c:v>TRAV5</c:v>
                </c:pt>
                <c:pt idx="37">
                  <c:v>TRAV6</c:v>
                </c:pt>
                <c:pt idx="38">
                  <c:v>TRAV7</c:v>
                </c:pt>
                <c:pt idx="39">
                  <c:v>TRAV8-1</c:v>
                </c:pt>
                <c:pt idx="40">
                  <c:v>TRAV8-2</c:v>
                </c:pt>
                <c:pt idx="41">
                  <c:v>TRAV8-3</c:v>
                </c:pt>
                <c:pt idx="42">
                  <c:v>TRAV8-6</c:v>
                </c:pt>
                <c:pt idx="43">
                  <c:v>TRAV9-1</c:v>
                </c:pt>
                <c:pt idx="44">
                  <c:v>TRAV9-2</c:v>
                </c:pt>
              </c:strCache>
            </c:strRef>
          </c:cat>
          <c:val>
            <c:numRef>
              <c:f>'2686'!$R$3:$R$47</c:f>
              <c:numCache>
                <c:formatCode>General</c:formatCode>
                <c:ptCount val="45"/>
                <c:pt idx="0">
                  <c:v>0.92152614400357113</c:v>
                </c:pt>
                <c:pt idx="1">
                  <c:v>-9.2989520081086861E-4</c:v>
                </c:pt>
                <c:pt idx="2">
                  <c:v>2.4363254261244763E-2</c:v>
                </c:pt>
                <c:pt idx="3">
                  <c:v>0.47666427993565141</c:v>
                </c:pt>
                <c:pt idx="4">
                  <c:v>61.058220738522785</c:v>
                </c:pt>
                <c:pt idx="5">
                  <c:v>0.15529249853541507</c:v>
                </c:pt>
                <c:pt idx="6">
                  <c:v>0.28175824584569326</c:v>
                </c:pt>
                <c:pt idx="7">
                  <c:v>0.10321836729000643</c:v>
                </c:pt>
                <c:pt idx="8">
                  <c:v>3.9241577474218657E-2</c:v>
                </c:pt>
                <c:pt idx="9">
                  <c:v>0.11214536121779077</c:v>
                </c:pt>
                <c:pt idx="10">
                  <c:v>7.792521782795081E-2</c:v>
                </c:pt>
                <c:pt idx="11">
                  <c:v>0.10916969657519598</c:v>
                </c:pt>
                <c:pt idx="12">
                  <c:v>1.3948428012163032E-2</c:v>
                </c:pt>
                <c:pt idx="13">
                  <c:v>0.83374403704702482</c:v>
                </c:pt>
                <c:pt idx="14">
                  <c:v>6.6022559257571681E-2</c:v>
                </c:pt>
                <c:pt idx="15">
                  <c:v>7.643738550665341E-2</c:v>
                </c:pt>
                <c:pt idx="16">
                  <c:v>8.5364379434437754E-2</c:v>
                </c:pt>
                <c:pt idx="17">
                  <c:v>5.0214340843786906E-3</c:v>
                </c:pt>
                <c:pt idx="18">
                  <c:v>2.1387589618649984E-2</c:v>
                </c:pt>
                <c:pt idx="19">
                  <c:v>1.0972763369568253E-2</c:v>
                </c:pt>
                <c:pt idx="20">
                  <c:v>6.007122997238213E-2</c:v>
                </c:pt>
                <c:pt idx="21">
                  <c:v>5.0214340843786906E-3</c:v>
                </c:pt>
                <c:pt idx="22">
                  <c:v>7.9970987269734721E-3</c:v>
                </c:pt>
                <c:pt idx="23">
                  <c:v>2.287542193994737E-2</c:v>
                </c:pt>
                <c:pt idx="24">
                  <c:v>0.17017082174838899</c:v>
                </c:pt>
                <c:pt idx="25">
                  <c:v>0.10916969657519598</c:v>
                </c:pt>
                <c:pt idx="26">
                  <c:v>5.0214340843786906E-3</c:v>
                </c:pt>
                <c:pt idx="27">
                  <c:v>7.9970987269734721E-3</c:v>
                </c:pt>
                <c:pt idx="28">
                  <c:v>3.0314583546434321E-2</c:v>
                </c:pt>
                <c:pt idx="29">
                  <c:v>4.2217242116813443E-2</c:v>
                </c:pt>
                <c:pt idx="30">
                  <c:v>1.2460595690865642E-2</c:v>
                </c:pt>
                <c:pt idx="31">
                  <c:v>6.3046894614976895E-2</c:v>
                </c:pt>
                <c:pt idx="32">
                  <c:v>2.7338918903839542E-2</c:v>
                </c:pt>
                <c:pt idx="33">
                  <c:v>5.2168980555891364</c:v>
                </c:pt>
                <c:pt idx="34">
                  <c:v>3.5336017630813012E-3</c:v>
                </c:pt>
                <c:pt idx="35">
                  <c:v>1.0972763369568253E-2</c:v>
                </c:pt>
                <c:pt idx="36">
                  <c:v>0.33383237709110186</c:v>
                </c:pt>
                <c:pt idx="37">
                  <c:v>0.73257143919880263</c:v>
                </c:pt>
                <c:pt idx="38">
                  <c:v>1.0972763369568253E-2</c:v>
                </c:pt>
                <c:pt idx="39">
                  <c:v>2.8826751225136935E-2</c:v>
                </c:pt>
                <c:pt idx="40">
                  <c:v>12.304931234249901</c:v>
                </c:pt>
                <c:pt idx="41">
                  <c:v>16.186685760514795</c:v>
                </c:pt>
                <c:pt idx="42">
                  <c:v>3.0314583546434321E-2</c:v>
                </c:pt>
                <c:pt idx="43">
                  <c:v>8.3876547113140368E-2</c:v>
                </c:pt>
                <c:pt idx="44">
                  <c:v>2.1387589618649984E-2</c:v>
                </c:pt>
              </c:numCache>
            </c:numRef>
          </c:val>
        </c:ser>
        <c:ser>
          <c:idx val="2"/>
          <c:order val="2"/>
          <c:tx>
            <c:strRef>
              <c:f>'2686'!$S$2</c:f>
              <c:strCache>
                <c:ptCount val="1"/>
                <c:pt idx="0">
                  <c:v>G-Rex</c:v>
                </c:pt>
              </c:strCache>
            </c:strRef>
          </c:tx>
          <c:spPr>
            <a:solidFill>
              <a:srgbClr val="0000CC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6'!$P$3:$P$47</c:f>
              <c:strCache>
                <c:ptCount val="45"/>
                <c:pt idx="0">
                  <c:v>TRAV10</c:v>
                </c:pt>
                <c:pt idx="1">
                  <c:v>TRAV11</c:v>
                </c:pt>
                <c:pt idx="2">
                  <c:v>TRAV1-1</c:v>
                </c:pt>
                <c:pt idx="3">
                  <c:v>TRAV1-2</c:v>
                </c:pt>
                <c:pt idx="4">
                  <c:v>TRAV12-1</c:v>
                </c:pt>
                <c:pt idx="5">
                  <c:v>TRAV12-2</c:v>
                </c:pt>
                <c:pt idx="6">
                  <c:v>TRAV12-3</c:v>
                </c:pt>
                <c:pt idx="7">
                  <c:v>TRAV13-1</c:v>
                </c:pt>
                <c:pt idx="8">
                  <c:v>TRAV13-2</c:v>
                </c:pt>
                <c:pt idx="9">
                  <c:v>TRAV14_DV4</c:v>
                </c:pt>
                <c:pt idx="10">
                  <c:v>TRAV16</c:v>
                </c:pt>
                <c:pt idx="11">
                  <c:v>TRAV17</c:v>
                </c:pt>
                <c:pt idx="12">
                  <c:v>TRAV18</c:v>
                </c:pt>
                <c:pt idx="13">
                  <c:v>TRAV19</c:v>
                </c:pt>
                <c:pt idx="14">
                  <c:v>TRAV2</c:v>
                </c:pt>
                <c:pt idx="15">
                  <c:v>TRAV20</c:v>
                </c:pt>
                <c:pt idx="16">
                  <c:v>TRAV21</c:v>
                </c:pt>
                <c:pt idx="17">
                  <c:v>TRAV22</c:v>
                </c:pt>
                <c:pt idx="18">
                  <c:v>TRAV23_DV6</c:v>
                </c:pt>
                <c:pt idx="19">
                  <c:v>TRAV24</c:v>
                </c:pt>
                <c:pt idx="20">
                  <c:v>TRAV25</c:v>
                </c:pt>
                <c:pt idx="21">
                  <c:v>TRAV26-1</c:v>
                </c:pt>
                <c:pt idx="22">
                  <c:v>TRAV26-2</c:v>
                </c:pt>
                <c:pt idx="23">
                  <c:v>TRAV27</c:v>
                </c:pt>
                <c:pt idx="24">
                  <c:v>TRAV29_DV5</c:v>
                </c:pt>
                <c:pt idx="25">
                  <c:v>TRAV3</c:v>
                </c:pt>
                <c:pt idx="26">
                  <c:v>TRAV30</c:v>
                </c:pt>
                <c:pt idx="27">
                  <c:v>TRAV34</c:v>
                </c:pt>
                <c:pt idx="28">
                  <c:v>TRAV35</c:v>
                </c:pt>
                <c:pt idx="29">
                  <c:v>TRAV36_DV7</c:v>
                </c:pt>
                <c:pt idx="30">
                  <c:v>TRAV38-1</c:v>
                </c:pt>
                <c:pt idx="31">
                  <c:v>TRAV38-2_DV8</c:v>
                </c:pt>
                <c:pt idx="32">
                  <c:v>TRAV39</c:v>
                </c:pt>
                <c:pt idx="33">
                  <c:v>TRAV4</c:v>
                </c:pt>
                <c:pt idx="34">
                  <c:v>TRAV40</c:v>
                </c:pt>
                <c:pt idx="35">
                  <c:v>TRAV41</c:v>
                </c:pt>
                <c:pt idx="36">
                  <c:v>TRAV5</c:v>
                </c:pt>
                <c:pt idx="37">
                  <c:v>TRAV6</c:v>
                </c:pt>
                <c:pt idx="38">
                  <c:v>TRAV7</c:v>
                </c:pt>
                <c:pt idx="39">
                  <c:v>TRAV8-1</c:v>
                </c:pt>
                <c:pt idx="40">
                  <c:v>TRAV8-2</c:v>
                </c:pt>
                <c:pt idx="41">
                  <c:v>TRAV8-3</c:v>
                </c:pt>
                <c:pt idx="42">
                  <c:v>TRAV8-6</c:v>
                </c:pt>
                <c:pt idx="43">
                  <c:v>TRAV9-1</c:v>
                </c:pt>
                <c:pt idx="44">
                  <c:v>TRAV9-2</c:v>
                </c:pt>
              </c:strCache>
            </c:strRef>
          </c:cat>
          <c:val>
            <c:numRef>
              <c:f>'2686'!$S$3:$S$47</c:f>
              <c:numCache>
                <c:formatCode>General</c:formatCode>
                <c:ptCount val="45"/>
                <c:pt idx="0">
                  <c:v>1.679783253773707</c:v>
                </c:pt>
                <c:pt idx="1">
                  <c:v>5.5680421541532852E-3</c:v>
                </c:pt>
                <c:pt idx="2">
                  <c:v>2.1321527273221116E-2</c:v>
                </c:pt>
                <c:pt idx="3">
                  <c:v>0.61941073817300318</c:v>
                </c:pt>
                <c:pt idx="4">
                  <c:v>51.917104074856226</c:v>
                </c:pt>
                <c:pt idx="5">
                  <c:v>0.15332486809851364</c:v>
                </c:pt>
                <c:pt idx="6">
                  <c:v>0.45590042710957512</c:v>
                </c:pt>
                <c:pt idx="7">
                  <c:v>0.13050947585710504</c:v>
                </c:pt>
                <c:pt idx="8">
                  <c:v>5.0112379387379571E-2</c:v>
                </c:pt>
                <c:pt idx="9">
                  <c:v>0.12942302860751417</c:v>
                </c:pt>
                <c:pt idx="10">
                  <c:v>7.890323150153801E-2</c:v>
                </c:pt>
                <c:pt idx="11">
                  <c:v>0.15006552634974096</c:v>
                </c:pt>
                <c:pt idx="12">
                  <c:v>4.4136919514629704E-2</c:v>
                </c:pt>
                <c:pt idx="13">
                  <c:v>0.7660811168677728</c:v>
                </c:pt>
                <c:pt idx="14">
                  <c:v>9.0854151247037745E-2</c:v>
                </c:pt>
                <c:pt idx="15">
                  <c:v>4.7396261263402358E-2</c:v>
                </c:pt>
                <c:pt idx="16">
                  <c:v>3.9791130516266163E-2</c:v>
                </c:pt>
                <c:pt idx="17">
                  <c:v>6.6544894037441696E-3</c:v>
                </c:pt>
                <c:pt idx="18">
                  <c:v>4.1420801390652483E-2</c:v>
                </c:pt>
                <c:pt idx="19">
                  <c:v>1.3173172901289479E-2</c:v>
                </c:pt>
                <c:pt idx="20">
                  <c:v>5.3371721136152218E-2</c:v>
                </c:pt>
                <c:pt idx="21">
                  <c:v>2.1864750898016556E-2</c:v>
                </c:pt>
                <c:pt idx="22">
                  <c:v>1.8062185524448462E-2</c:v>
                </c:pt>
                <c:pt idx="23">
                  <c:v>2.1321527273221116E-2</c:v>
                </c:pt>
                <c:pt idx="24">
                  <c:v>0.11421276711324176</c:v>
                </c:pt>
                <c:pt idx="25">
                  <c:v>8.7594809498265092E-2</c:v>
                </c:pt>
                <c:pt idx="26">
                  <c:v>1.3173172901289479E-2</c:v>
                </c:pt>
                <c:pt idx="27">
                  <c:v>2.3087004053806304E-3</c:v>
                </c:pt>
                <c:pt idx="28">
                  <c:v>3.0556328894743641E-2</c:v>
                </c:pt>
                <c:pt idx="29">
                  <c:v>3.7075012392288949E-2</c:v>
                </c:pt>
                <c:pt idx="30">
                  <c:v>2.675376352117554E-2</c:v>
                </c:pt>
                <c:pt idx="31">
                  <c:v>6.6952311756038274E-2</c:v>
                </c:pt>
                <c:pt idx="32">
                  <c:v>1.5346067400471248E-2</c:v>
                </c:pt>
                <c:pt idx="33">
                  <c:v>9.4473378647237407</c:v>
                </c:pt>
                <c:pt idx="34">
                  <c:v>2.3087004053806304E-3</c:v>
                </c:pt>
                <c:pt idx="35">
                  <c:v>2.0235080023630232E-2</c:v>
                </c:pt>
                <c:pt idx="36">
                  <c:v>0.63733711779125291</c:v>
                </c:pt>
                <c:pt idx="37">
                  <c:v>1.0061859590273583</c:v>
                </c:pt>
                <c:pt idx="38">
                  <c:v>1.2086725651698596E-2</c:v>
                </c:pt>
                <c:pt idx="39">
                  <c:v>1.6432514650062135E-2</c:v>
                </c:pt>
                <c:pt idx="40">
                  <c:v>14.898586939546002</c:v>
                </c:pt>
                <c:pt idx="41">
                  <c:v>16.867229355804689</c:v>
                </c:pt>
                <c:pt idx="42">
                  <c:v>2.9469881645152757E-2</c:v>
                </c:pt>
                <c:pt idx="43">
                  <c:v>8.0532902375924351E-2</c:v>
                </c:pt>
                <c:pt idx="44">
                  <c:v>3.2729223393925408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906787376"/>
        <c:axId val="906787936"/>
      </c:barChart>
      <c:catAx>
        <c:axId val="906787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 b="1"/>
            </a:pPr>
            <a:endParaRPr lang="en-US"/>
          </a:p>
        </c:txPr>
        <c:crossAx val="906787936"/>
        <c:crosses val="autoZero"/>
        <c:auto val="1"/>
        <c:lblAlgn val="ctr"/>
        <c:lblOffset val="100"/>
        <c:noMultiLvlLbl val="0"/>
      </c:catAx>
      <c:valAx>
        <c:axId val="906787936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90678737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5840211161553387E-2"/>
          <c:y val="3.7248511422963732E-2"/>
          <c:w val="0.95415978883844665"/>
          <c:h val="0.724645396130069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2686'!$Q$50</c:f>
              <c:strCache>
                <c:ptCount val="1"/>
                <c:pt idx="0">
                  <c:v>Pre-REP</c:v>
                </c:pt>
              </c:strCache>
            </c:strRef>
          </c:tx>
          <c:spPr>
            <a:solidFill>
              <a:sysClr val="window" lastClr="FFFFFF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6'!$P$51:$P$96</c:f>
              <c:strCache>
                <c:ptCount val="46"/>
                <c:pt idx="0">
                  <c:v>TRBV10-1</c:v>
                </c:pt>
                <c:pt idx="1">
                  <c:v>TRBV10-2</c:v>
                </c:pt>
                <c:pt idx="2">
                  <c:v>TRBV10-3</c:v>
                </c:pt>
                <c:pt idx="3">
                  <c:v>TRBV11-1</c:v>
                </c:pt>
                <c:pt idx="4">
                  <c:v>TRBV11-2</c:v>
                </c:pt>
                <c:pt idx="5">
                  <c:v>TRBV11-3</c:v>
                </c:pt>
                <c:pt idx="6">
                  <c:v>TRBV12-3</c:v>
                </c:pt>
                <c:pt idx="7">
                  <c:v>TRBV12-5</c:v>
                </c:pt>
                <c:pt idx="8">
                  <c:v>TRBV13</c:v>
                </c:pt>
                <c:pt idx="9">
                  <c:v>TRBV14</c:v>
                </c:pt>
                <c:pt idx="10">
                  <c:v>TRBV15</c:v>
                </c:pt>
                <c:pt idx="11">
                  <c:v>TRBV16</c:v>
                </c:pt>
                <c:pt idx="12">
                  <c:v>TRBV18</c:v>
                </c:pt>
                <c:pt idx="13">
                  <c:v>TRBV19</c:v>
                </c:pt>
                <c:pt idx="14">
                  <c:v>TRBV2</c:v>
                </c:pt>
                <c:pt idx="15">
                  <c:v>TRBV20-1</c:v>
                </c:pt>
                <c:pt idx="16">
                  <c:v>TRBV24-1</c:v>
                </c:pt>
                <c:pt idx="17">
                  <c:v>TRBV25-1</c:v>
                </c:pt>
                <c:pt idx="18">
                  <c:v>TRBV27</c:v>
                </c:pt>
                <c:pt idx="19">
                  <c:v>TRBV28</c:v>
                </c:pt>
                <c:pt idx="20">
                  <c:v>TRBV29-1</c:v>
                </c:pt>
                <c:pt idx="21">
                  <c:v>TRBV30</c:v>
                </c:pt>
                <c:pt idx="22">
                  <c:v>TRBV3-1</c:v>
                </c:pt>
                <c:pt idx="23">
                  <c:v>TRBV4-1</c:v>
                </c:pt>
                <c:pt idx="24">
                  <c:v>TRBV4-2</c:v>
                </c:pt>
                <c:pt idx="25">
                  <c:v>TRBV4-3</c:v>
                </c:pt>
                <c:pt idx="26">
                  <c:v>TRBV5-1</c:v>
                </c:pt>
                <c:pt idx="27">
                  <c:v>TRBV5-4</c:v>
                </c:pt>
                <c:pt idx="28">
                  <c:v>TRBV5-5</c:v>
                </c:pt>
                <c:pt idx="29">
                  <c:v>TRBV5-6</c:v>
                </c:pt>
                <c:pt idx="30">
                  <c:v>TRBV5-8</c:v>
                </c:pt>
                <c:pt idx="31">
                  <c:v>TRBV6-1</c:v>
                </c:pt>
                <c:pt idx="32">
                  <c:v>TRBV6-2</c:v>
                </c:pt>
                <c:pt idx="33">
                  <c:v>TRBV6-4</c:v>
                </c:pt>
                <c:pt idx="34">
                  <c:v>TRBV6-5</c:v>
                </c:pt>
                <c:pt idx="35">
                  <c:v>TRBV6-6</c:v>
                </c:pt>
                <c:pt idx="36">
                  <c:v>TRBV6-8</c:v>
                </c:pt>
                <c:pt idx="37">
                  <c:v>TRBV6-9</c:v>
                </c:pt>
                <c:pt idx="38">
                  <c:v>TRBV7-2</c:v>
                </c:pt>
                <c:pt idx="39">
                  <c:v>TRBV7-3</c:v>
                </c:pt>
                <c:pt idx="40">
                  <c:v>TRBV7-4</c:v>
                </c:pt>
                <c:pt idx="41">
                  <c:v>TRBV7-6</c:v>
                </c:pt>
                <c:pt idx="42">
                  <c:v>TRBV7-7</c:v>
                </c:pt>
                <c:pt idx="43">
                  <c:v>TRBV7-8</c:v>
                </c:pt>
                <c:pt idx="44">
                  <c:v>TRBV7-9</c:v>
                </c:pt>
                <c:pt idx="45">
                  <c:v>TRBV9</c:v>
                </c:pt>
              </c:strCache>
            </c:strRef>
          </c:cat>
          <c:val>
            <c:numRef>
              <c:f>'2686'!$Q$51:$Q$96</c:f>
              <c:numCache>
                <c:formatCode>General</c:formatCode>
                <c:ptCount val="46"/>
                <c:pt idx="0">
                  <c:v>2.1538212200437588E-2</c:v>
                </c:pt>
                <c:pt idx="1">
                  <c:v>1.3008227170561314E-2</c:v>
                </c:pt>
                <c:pt idx="2">
                  <c:v>8.8072095433472511E-2</c:v>
                </c:pt>
                <c:pt idx="3">
                  <c:v>1.812621818848708E-2</c:v>
                </c:pt>
                <c:pt idx="4">
                  <c:v>0.14266399962468063</c:v>
                </c:pt>
                <c:pt idx="5">
                  <c:v>4.201017627214064E-2</c:v>
                </c:pt>
                <c:pt idx="6">
                  <c:v>0.56916325111849431</c:v>
                </c:pt>
                <c:pt idx="7">
                  <c:v>2.7722451347097885E-3</c:v>
                </c:pt>
                <c:pt idx="8">
                  <c:v>4.201017627214064E-2</c:v>
                </c:pt>
                <c:pt idx="9">
                  <c:v>11.97034124205112</c:v>
                </c:pt>
                <c:pt idx="10">
                  <c:v>2.4950206212388092E-2</c:v>
                </c:pt>
                <c:pt idx="11">
                  <c:v>7.8902361526355519E-3</c:v>
                </c:pt>
                <c:pt idx="12">
                  <c:v>1.2345020834488436</c:v>
                </c:pt>
                <c:pt idx="13">
                  <c:v>51.192918406428191</c:v>
                </c:pt>
                <c:pt idx="14">
                  <c:v>4.0304179266165384E-2</c:v>
                </c:pt>
                <c:pt idx="15">
                  <c:v>2.4167580085896945</c:v>
                </c:pt>
                <c:pt idx="16">
                  <c:v>0.48556939782570679</c:v>
                </c:pt>
                <c:pt idx="17">
                  <c:v>1.2737400145862743</c:v>
                </c:pt>
                <c:pt idx="18">
                  <c:v>9.8308077469324046E-2</c:v>
                </c:pt>
                <c:pt idx="19">
                  <c:v>18.294472143201389</c:v>
                </c:pt>
                <c:pt idx="20">
                  <c:v>0.12219203555297758</c:v>
                </c:pt>
                <c:pt idx="21">
                  <c:v>2.8362200224338607E-2</c:v>
                </c:pt>
                <c:pt idx="22">
                  <c:v>2.3244209206412843E-2</c:v>
                </c:pt>
                <c:pt idx="23">
                  <c:v>0.25184780800709694</c:v>
                </c:pt>
                <c:pt idx="24">
                  <c:v>5.2246158307992167E-2</c:v>
                </c:pt>
                <c:pt idx="25">
                  <c:v>-6.3974887724072037E-4</c:v>
                </c:pt>
                <c:pt idx="26">
                  <c:v>3.1774194236289112E-2</c:v>
                </c:pt>
                <c:pt idx="27">
                  <c:v>6.184239146660297E-3</c:v>
                </c:pt>
                <c:pt idx="28">
                  <c:v>0.17337194573223522</c:v>
                </c:pt>
                <c:pt idx="29">
                  <c:v>3.8549134846268345</c:v>
                </c:pt>
                <c:pt idx="30">
                  <c:v>2.7722451347097885E-3</c:v>
                </c:pt>
                <c:pt idx="31">
                  <c:v>3.5186188248239623E-2</c:v>
                </c:pt>
                <c:pt idx="32">
                  <c:v>1.1302230164586062E-2</c:v>
                </c:pt>
                <c:pt idx="33">
                  <c:v>2.7722451347097885E-3</c:v>
                </c:pt>
                <c:pt idx="34">
                  <c:v>5.9070146331893184E-2</c:v>
                </c:pt>
                <c:pt idx="35">
                  <c:v>9.5962331586108059E-3</c:v>
                </c:pt>
                <c:pt idx="36">
                  <c:v>7.8902361526355519E-3</c:v>
                </c:pt>
                <c:pt idx="37">
                  <c:v>6.9306128367744718E-2</c:v>
                </c:pt>
                <c:pt idx="38">
                  <c:v>1.812621818848708E-2</c:v>
                </c:pt>
                <c:pt idx="39">
                  <c:v>2.4950206212388092E-2</c:v>
                </c:pt>
                <c:pt idx="40">
                  <c:v>3.8598182260190135E-2</c:v>
                </c:pt>
                <c:pt idx="41">
                  <c:v>1.1302230164586062E-2</c:v>
                </c:pt>
                <c:pt idx="42">
                  <c:v>7.8902361526355519E-3</c:v>
                </c:pt>
                <c:pt idx="43">
                  <c:v>8.6366098427497248E-2</c:v>
                </c:pt>
                <c:pt idx="44">
                  <c:v>6.4719128917928748</c:v>
                </c:pt>
                <c:pt idx="45">
                  <c:v>0.62034316129775191</c:v>
                </c:pt>
              </c:numCache>
            </c:numRef>
          </c:val>
        </c:ser>
        <c:ser>
          <c:idx val="1"/>
          <c:order val="1"/>
          <c:tx>
            <c:strRef>
              <c:f>'2686'!$R$50</c:f>
              <c:strCache>
                <c:ptCount val="1"/>
                <c:pt idx="0">
                  <c:v>Bag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6'!$P$51:$P$96</c:f>
              <c:strCache>
                <c:ptCount val="46"/>
                <c:pt idx="0">
                  <c:v>TRBV10-1</c:v>
                </c:pt>
                <c:pt idx="1">
                  <c:v>TRBV10-2</c:v>
                </c:pt>
                <c:pt idx="2">
                  <c:v>TRBV10-3</c:v>
                </c:pt>
                <c:pt idx="3">
                  <c:v>TRBV11-1</c:v>
                </c:pt>
                <c:pt idx="4">
                  <c:v>TRBV11-2</c:v>
                </c:pt>
                <c:pt idx="5">
                  <c:v>TRBV11-3</c:v>
                </c:pt>
                <c:pt idx="6">
                  <c:v>TRBV12-3</c:v>
                </c:pt>
                <c:pt idx="7">
                  <c:v>TRBV12-5</c:v>
                </c:pt>
                <c:pt idx="8">
                  <c:v>TRBV13</c:v>
                </c:pt>
                <c:pt idx="9">
                  <c:v>TRBV14</c:v>
                </c:pt>
                <c:pt idx="10">
                  <c:v>TRBV15</c:v>
                </c:pt>
                <c:pt idx="11">
                  <c:v>TRBV16</c:v>
                </c:pt>
                <c:pt idx="12">
                  <c:v>TRBV18</c:v>
                </c:pt>
                <c:pt idx="13">
                  <c:v>TRBV19</c:v>
                </c:pt>
                <c:pt idx="14">
                  <c:v>TRBV2</c:v>
                </c:pt>
                <c:pt idx="15">
                  <c:v>TRBV20-1</c:v>
                </c:pt>
                <c:pt idx="16">
                  <c:v>TRBV24-1</c:v>
                </c:pt>
                <c:pt idx="17">
                  <c:v>TRBV25-1</c:v>
                </c:pt>
                <c:pt idx="18">
                  <c:v>TRBV27</c:v>
                </c:pt>
                <c:pt idx="19">
                  <c:v>TRBV28</c:v>
                </c:pt>
                <c:pt idx="20">
                  <c:v>TRBV29-1</c:v>
                </c:pt>
                <c:pt idx="21">
                  <c:v>TRBV30</c:v>
                </c:pt>
                <c:pt idx="22">
                  <c:v>TRBV3-1</c:v>
                </c:pt>
                <c:pt idx="23">
                  <c:v>TRBV4-1</c:v>
                </c:pt>
                <c:pt idx="24">
                  <c:v>TRBV4-2</c:v>
                </c:pt>
                <c:pt idx="25">
                  <c:v>TRBV4-3</c:v>
                </c:pt>
                <c:pt idx="26">
                  <c:v>TRBV5-1</c:v>
                </c:pt>
                <c:pt idx="27">
                  <c:v>TRBV5-4</c:v>
                </c:pt>
                <c:pt idx="28">
                  <c:v>TRBV5-5</c:v>
                </c:pt>
                <c:pt idx="29">
                  <c:v>TRBV5-6</c:v>
                </c:pt>
                <c:pt idx="30">
                  <c:v>TRBV5-8</c:v>
                </c:pt>
                <c:pt idx="31">
                  <c:v>TRBV6-1</c:v>
                </c:pt>
                <c:pt idx="32">
                  <c:v>TRBV6-2</c:v>
                </c:pt>
                <c:pt idx="33">
                  <c:v>TRBV6-4</c:v>
                </c:pt>
                <c:pt idx="34">
                  <c:v>TRBV6-5</c:v>
                </c:pt>
                <c:pt idx="35">
                  <c:v>TRBV6-6</c:v>
                </c:pt>
                <c:pt idx="36">
                  <c:v>TRBV6-8</c:v>
                </c:pt>
                <c:pt idx="37">
                  <c:v>TRBV6-9</c:v>
                </c:pt>
                <c:pt idx="38">
                  <c:v>TRBV7-2</c:v>
                </c:pt>
                <c:pt idx="39">
                  <c:v>TRBV7-3</c:v>
                </c:pt>
                <c:pt idx="40">
                  <c:v>TRBV7-4</c:v>
                </c:pt>
                <c:pt idx="41">
                  <c:v>TRBV7-6</c:v>
                </c:pt>
                <c:pt idx="42">
                  <c:v>TRBV7-7</c:v>
                </c:pt>
                <c:pt idx="43">
                  <c:v>TRBV7-8</c:v>
                </c:pt>
                <c:pt idx="44">
                  <c:v>TRBV7-9</c:v>
                </c:pt>
                <c:pt idx="45">
                  <c:v>TRBV9</c:v>
                </c:pt>
              </c:strCache>
            </c:strRef>
          </c:cat>
          <c:val>
            <c:numRef>
              <c:f>'2686'!$R$51:$R$96</c:f>
              <c:numCache>
                <c:formatCode>General</c:formatCode>
                <c:ptCount val="46"/>
                <c:pt idx="0">
                  <c:v>1.5171617770426648E-2</c:v>
                </c:pt>
                <c:pt idx="1">
                  <c:v>3.183064904775787E-2</c:v>
                </c:pt>
                <c:pt idx="2">
                  <c:v>5.324940354718373E-2</c:v>
                </c:pt>
                <c:pt idx="3">
                  <c:v>8.9244810414274413E-4</c:v>
                </c:pt>
                <c:pt idx="4">
                  <c:v>0.39118975231590275</c:v>
                </c:pt>
                <c:pt idx="5">
                  <c:v>5.6521713262373792E-3</c:v>
                </c:pt>
                <c:pt idx="6">
                  <c:v>5.324940354718373E-2</c:v>
                </c:pt>
                <c:pt idx="7">
                  <c:v>-1.4874135069045734E-3</c:v>
                </c:pt>
                <c:pt idx="8">
                  <c:v>4.8489680325089088E-2</c:v>
                </c:pt>
                <c:pt idx="9">
                  <c:v>1.5668413881732777</c:v>
                </c:pt>
                <c:pt idx="10">
                  <c:v>6.514871160242032E-2</c:v>
                </c:pt>
                <c:pt idx="11">
                  <c:v>8.9244810414274413E-4</c:v>
                </c:pt>
                <c:pt idx="12">
                  <c:v>1.9476192459408483</c:v>
                </c:pt>
                <c:pt idx="13">
                  <c:v>91.466113745485686</c:v>
                </c:pt>
                <c:pt idx="14">
                  <c:v>2.4691064214615921E-2</c:v>
                </c:pt>
                <c:pt idx="15">
                  <c:v>0.4340272613147545</c:v>
                </c:pt>
                <c:pt idx="16">
                  <c:v>6.7528573213467627E-2</c:v>
                </c:pt>
                <c:pt idx="17">
                  <c:v>8.9244810414274413E-4</c:v>
                </c:pt>
                <c:pt idx="18">
                  <c:v>0.20318068504316472</c:v>
                </c:pt>
                <c:pt idx="19">
                  <c:v>0.51732241770141063</c:v>
                </c:pt>
                <c:pt idx="20">
                  <c:v>8.1807742879751538E-2</c:v>
                </c:pt>
                <c:pt idx="21">
                  <c:v>1.5171617770426648E-2</c:v>
                </c:pt>
                <c:pt idx="22">
                  <c:v>6.2768849991372999E-2</c:v>
                </c:pt>
                <c:pt idx="23">
                  <c:v>0.13416469832279251</c:v>
                </c:pt>
                <c:pt idx="24">
                  <c:v>5.0869541936136409E-2</c:v>
                </c:pt>
                <c:pt idx="25">
                  <c:v>-3.8672751179518908E-3</c:v>
                </c:pt>
                <c:pt idx="26">
                  <c:v>3.8970233880899832E-2</c:v>
                </c:pt>
                <c:pt idx="27">
                  <c:v>1.2791756159379332E-2</c:v>
                </c:pt>
                <c:pt idx="28">
                  <c:v>6.514871160242032E-2</c:v>
                </c:pt>
                <c:pt idx="29">
                  <c:v>1.1527454678510443</c:v>
                </c:pt>
                <c:pt idx="30">
                  <c:v>8.9244810414274413E-4</c:v>
                </c:pt>
                <c:pt idx="31">
                  <c:v>4.6109818714041774E-2</c:v>
                </c:pt>
                <c:pt idx="32">
                  <c:v>3.183064904775787E-2</c:v>
                </c:pt>
                <c:pt idx="33">
                  <c:v>1.0411894548332013E-2</c:v>
                </c:pt>
                <c:pt idx="34">
                  <c:v>0.13654455993383985</c:v>
                </c:pt>
                <c:pt idx="35">
                  <c:v>5.8009126769278364E-2</c:v>
                </c:pt>
                <c:pt idx="36">
                  <c:v>8.0320329372846958E-3</c:v>
                </c:pt>
                <c:pt idx="37">
                  <c:v>0.13654455993383985</c:v>
                </c:pt>
                <c:pt idx="38">
                  <c:v>2.4691064214615921E-2</c:v>
                </c:pt>
                <c:pt idx="39">
                  <c:v>3.8970233880899832E-2</c:v>
                </c:pt>
                <c:pt idx="40">
                  <c:v>3.2723097151900618E-3</c:v>
                </c:pt>
                <c:pt idx="41">
                  <c:v>1.7551479381473969E-2</c:v>
                </c:pt>
                <c:pt idx="42">
                  <c:v>-1.4874135069045734E-3</c:v>
                </c:pt>
                <c:pt idx="43">
                  <c:v>0.14130428315593446</c:v>
                </c:pt>
                <c:pt idx="44">
                  <c:v>0.62441619019854</c:v>
                </c:pt>
                <c:pt idx="45">
                  <c:v>0.21983971632049595</c:v>
                </c:pt>
              </c:numCache>
            </c:numRef>
          </c:val>
        </c:ser>
        <c:ser>
          <c:idx val="2"/>
          <c:order val="2"/>
          <c:tx>
            <c:strRef>
              <c:f>'2686'!$S$50</c:f>
              <c:strCache>
                <c:ptCount val="1"/>
                <c:pt idx="0">
                  <c:v>G-Rex</c:v>
                </c:pt>
              </c:strCache>
            </c:strRef>
          </c:tx>
          <c:spPr>
            <a:solidFill>
              <a:srgbClr val="0000CC"/>
            </a:solidFill>
            <a:ln>
              <a:solidFill>
                <a:sysClr val="windowText" lastClr="000000"/>
              </a:solidFill>
            </a:ln>
          </c:spPr>
          <c:invertIfNegative val="0"/>
          <c:cat>
            <c:strRef>
              <c:f>'2686'!$P$51:$P$96</c:f>
              <c:strCache>
                <c:ptCount val="46"/>
                <c:pt idx="0">
                  <c:v>TRBV10-1</c:v>
                </c:pt>
                <c:pt idx="1">
                  <c:v>TRBV10-2</c:v>
                </c:pt>
                <c:pt idx="2">
                  <c:v>TRBV10-3</c:v>
                </c:pt>
                <c:pt idx="3">
                  <c:v>TRBV11-1</c:v>
                </c:pt>
                <c:pt idx="4">
                  <c:v>TRBV11-2</c:v>
                </c:pt>
                <c:pt idx="5">
                  <c:v>TRBV11-3</c:v>
                </c:pt>
                <c:pt idx="6">
                  <c:v>TRBV12-3</c:v>
                </c:pt>
                <c:pt idx="7">
                  <c:v>TRBV12-5</c:v>
                </c:pt>
                <c:pt idx="8">
                  <c:v>TRBV13</c:v>
                </c:pt>
                <c:pt idx="9">
                  <c:v>TRBV14</c:v>
                </c:pt>
                <c:pt idx="10">
                  <c:v>TRBV15</c:v>
                </c:pt>
                <c:pt idx="11">
                  <c:v>TRBV16</c:v>
                </c:pt>
                <c:pt idx="12">
                  <c:v>TRBV18</c:v>
                </c:pt>
                <c:pt idx="13">
                  <c:v>TRBV19</c:v>
                </c:pt>
                <c:pt idx="14">
                  <c:v>TRBV2</c:v>
                </c:pt>
                <c:pt idx="15">
                  <c:v>TRBV20-1</c:v>
                </c:pt>
                <c:pt idx="16">
                  <c:v>TRBV24-1</c:v>
                </c:pt>
                <c:pt idx="17">
                  <c:v>TRBV25-1</c:v>
                </c:pt>
                <c:pt idx="18">
                  <c:v>TRBV27</c:v>
                </c:pt>
                <c:pt idx="19">
                  <c:v>TRBV28</c:v>
                </c:pt>
                <c:pt idx="20">
                  <c:v>TRBV29-1</c:v>
                </c:pt>
                <c:pt idx="21">
                  <c:v>TRBV30</c:v>
                </c:pt>
                <c:pt idx="22">
                  <c:v>TRBV3-1</c:v>
                </c:pt>
                <c:pt idx="23">
                  <c:v>TRBV4-1</c:v>
                </c:pt>
                <c:pt idx="24">
                  <c:v>TRBV4-2</c:v>
                </c:pt>
                <c:pt idx="25">
                  <c:v>TRBV4-3</c:v>
                </c:pt>
                <c:pt idx="26">
                  <c:v>TRBV5-1</c:v>
                </c:pt>
                <c:pt idx="27">
                  <c:v>TRBV5-4</c:v>
                </c:pt>
                <c:pt idx="28">
                  <c:v>TRBV5-5</c:v>
                </c:pt>
                <c:pt idx="29">
                  <c:v>TRBV5-6</c:v>
                </c:pt>
                <c:pt idx="30">
                  <c:v>TRBV5-8</c:v>
                </c:pt>
                <c:pt idx="31">
                  <c:v>TRBV6-1</c:v>
                </c:pt>
                <c:pt idx="32">
                  <c:v>TRBV6-2</c:v>
                </c:pt>
                <c:pt idx="33">
                  <c:v>TRBV6-4</c:v>
                </c:pt>
                <c:pt idx="34">
                  <c:v>TRBV6-5</c:v>
                </c:pt>
                <c:pt idx="35">
                  <c:v>TRBV6-6</c:v>
                </c:pt>
                <c:pt idx="36">
                  <c:v>TRBV6-8</c:v>
                </c:pt>
                <c:pt idx="37">
                  <c:v>TRBV6-9</c:v>
                </c:pt>
                <c:pt idx="38">
                  <c:v>TRBV7-2</c:v>
                </c:pt>
                <c:pt idx="39">
                  <c:v>TRBV7-3</c:v>
                </c:pt>
                <c:pt idx="40">
                  <c:v>TRBV7-4</c:v>
                </c:pt>
                <c:pt idx="41">
                  <c:v>TRBV7-6</c:v>
                </c:pt>
                <c:pt idx="42">
                  <c:v>TRBV7-7</c:v>
                </c:pt>
                <c:pt idx="43">
                  <c:v>TRBV7-8</c:v>
                </c:pt>
                <c:pt idx="44">
                  <c:v>TRBV7-9</c:v>
                </c:pt>
                <c:pt idx="45">
                  <c:v>TRBV9</c:v>
                </c:pt>
              </c:strCache>
            </c:strRef>
          </c:cat>
          <c:val>
            <c:numRef>
              <c:f>'2686'!$S$51:$S$96</c:f>
              <c:numCache>
                <c:formatCode>General</c:formatCode>
                <c:ptCount val="46"/>
                <c:pt idx="0">
                  <c:v>2.0532333716352404E-2</c:v>
                </c:pt>
                <c:pt idx="1">
                  <c:v>2.0532333716352404E-2</c:v>
                </c:pt>
                <c:pt idx="2">
                  <c:v>7.4029423399325639E-2</c:v>
                </c:pt>
                <c:pt idx="3">
                  <c:v>1.2244052216173451E-2</c:v>
                </c:pt>
                <c:pt idx="4">
                  <c:v>0.32192438826831432</c:v>
                </c:pt>
                <c:pt idx="5">
                  <c:v>4.7092508523744053E-3</c:v>
                </c:pt>
                <c:pt idx="6">
                  <c:v>6.2727221353627086E-2</c:v>
                </c:pt>
                <c:pt idx="7">
                  <c:v>3.2022905796145955E-3</c:v>
                </c:pt>
                <c:pt idx="8">
                  <c:v>2.1285813852732309E-2</c:v>
                </c:pt>
                <c:pt idx="9">
                  <c:v>2.0089664136229208</c:v>
                </c:pt>
                <c:pt idx="10">
                  <c:v>8.8345545990543825E-2</c:v>
                </c:pt>
                <c:pt idx="11">
                  <c:v>4.7092508523744053E-3</c:v>
                </c:pt>
                <c:pt idx="12">
                  <c:v>2.8656733286868725</c:v>
                </c:pt>
                <c:pt idx="13">
                  <c:v>90.134496204343819</c:v>
                </c:pt>
                <c:pt idx="14">
                  <c:v>2.3546254261872023E-2</c:v>
                </c:pt>
                <c:pt idx="15">
                  <c:v>0.52611750522726852</c:v>
                </c:pt>
                <c:pt idx="16">
                  <c:v>9.2112946672443352E-2</c:v>
                </c:pt>
                <c:pt idx="17">
                  <c:v>4.7092508523744053E-3</c:v>
                </c:pt>
                <c:pt idx="18">
                  <c:v>0.18479100344717164</c:v>
                </c:pt>
                <c:pt idx="19">
                  <c:v>0.23452069244824536</c:v>
                </c:pt>
                <c:pt idx="20">
                  <c:v>9.4373387081583077E-2</c:v>
                </c:pt>
                <c:pt idx="21">
                  <c:v>2.9574095352911261E-2</c:v>
                </c:pt>
                <c:pt idx="22">
                  <c:v>3.7108896716710311E-2</c:v>
                </c:pt>
                <c:pt idx="23">
                  <c:v>0.17122836099233338</c:v>
                </c:pt>
                <c:pt idx="24">
                  <c:v>9.1359466536063444E-2</c:v>
                </c:pt>
                <c:pt idx="25">
                  <c:v>-2.0720703750447384E-3</c:v>
                </c:pt>
                <c:pt idx="26">
                  <c:v>2.8820615216531356E-2</c:v>
                </c:pt>
                <c:pt idx="27">
                  <c:v>2.0532333716352404E-2</c:v>
                </c:pt>
                <c:pt idx="28">
                  <c:v>6.9508542581046218E-2</c:v>
                </c:pt>
                <c:pt idx="29">
                  <c:v>1.2848720025618325</c:v>
                </c:pt>
                <c:pt idx="30">
                  <c:v>9.4185017047488089E-4</c:v>
                </c:pt>
                <c:pt idx="31">
                  <c:v>3.5601936443950502E-2</c:v>
                </c:pt>
                <c:pt idx="32">
                  <c:v>1.7518413170832785E-2</c:v>
                </c:pt>
                <c:pt idx="33">
                  <c:v>1.2244052216173451E-2</c:v>
                </c:pt>
                <c:pt idx="34">
                  <c:v>0.14787047676455631</c:v>
                </c:pt>
                <c:pt idx="35">
                  <c:v>7.628986380846535E-2</c:v>
                </c:pt>
                <c:pt idx="36">
                  <c:v>7.7231713978940242E-3</c:v>
                </c:pt>
                <c:pt idx="37">
                  <c:v>0.18102360276527213</c:v>
                </c:pt>
                <c:pt idx="38">
                  <c:v>3.1834535762050975E-2</c:v>
                </c:pt>
                <c:pt idx="39">
                  <c:v>4.3136737807749549E-2</c:v>
                </c:pt>
                <c:pt idx="40">
                  <c:v>9.9836118070337366E-3</c:v>
                </c:pt>
                <c:pt idx="41">
                  <c:v>1.450449262531317E-2</c:v>
                </c:pt>
                <c:pt idx="42">
                  <c:v>5.4627309887543092E-3</c:v>
                </c:pt>
                <c:pt idx="43">
                  <c:v>0.1004012281726223</c:v>
                </c:pt>
                <c:pt idx="44">
                  <c:v>0.54872190931866549</c:v>
                </c:pt>
                <c:pt idx="45">
                  <c:v>0.232260252039105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79547552"/>
        <c:axId val="179548112"/>
      </c:barChart>
      <c:catAx>
        <c:axId val="179547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800" b="1"/>
            </a:pPr>
            <a:endParaRPr lang="en-US"/>
          </a:p>
        </c:txPr>
        <c:crossAx val="179548112"/>
        <c:crosses val="autoZero"/>
        <c:auto val="1"/>
        <c:lblAlgn val="ctr"/>
        <c:lblOffset val="100"/>
        <c:noMultiLvlLbl val="0"/>
      </c:catAx>
      <c:valAx>
        <c:axId val="179548112"/>
        <c:scaling>
          <c:orientation val="minMax"/>
          <c:min val="0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79547552"/>
        <c:crosses val="autoZero"/>
        <c:crossBetween val="between"/>
        <c:majorUnit val="2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8054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398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6267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424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2772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3142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908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8852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22967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6811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62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5C60D3-A4D4-4E9E-BCD3-0F8F25FBED05}" type="datetimeFigureOut">
              <a:rPr lang="en-US" smtClean="0"/>
              <a:t>5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E5B32-6927-484D-A9CF-BA43658DD8E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0529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24493" y="20320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33"/>
          <p:cNvSpPr txBox="1">
            <a:spLocks noChangeArrowheads="1"/>
          </p:cNvSpPr>
          <p:nvPr/>
        </p:nvSpPr>
        <p:spPr bwMode="auto">
          <a:xfrm rot="16200000">
            <a:off x="-556862" y="1357528"/>
            <a:ext cx="14302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CA" altLang="en-US" sz="1000" b="1" dirty="0">
                <a:latin typeface="Arial" charset="0"/>
              </a:rPr>
              <a:t>% of total TCR alpha</a:t>
            </a:r>
            <a:endParaRPr lang="fr-CA" altLang="en-US" sz="1000" b="1" dirty="0">
              <a:latin typeface="Arial" charset="0"/>
            </a:endParaRPr>
          </a:p>
        </p:txBody>
      </p:sp>
      <p:sp>
        <p:nvSpPr>
          <p:cNvPr id="13" name="ZoneTexte 34"/>
          <p:cNvSpPr txBox="1">
            <a:spLocks noChangeArrowheads="1"/>
          </p:cNvSpPr>
          <p:nvPr/>
        </p:nvSpPr>
        <p:spPr bwMode="auto">
          <a:xfrm rot="16200000">
            <a:off x="-537789" y="3207561"/>
            <a:ext cx="13596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CA" altLang="en-US" sz="1000" b="1" dirty="0">
                <a:latin typeface="Arial" charset="0"/>
              </a:rPr>
              <a:t>% of total TCR beta</a:t>
            </a:r>
            <a:endParaRPr lang="fr-CA" altLang="en-US" sz="1000" b="1" dirty="0">
              <a:latin typeface="Arial" charset="0"/>
            </a:endParaRPr>
          </a:p>
        </p:txBody>
      </p:sp>
      <p:sp>
        <p:nvSpPr>
          <p:cNvPr id="14" name="ZoneTexte 33"/>
          <p:cNvSpPr txBox="1">
            <a:spLocks noChangeArrowheads="1"/>
          </p:cNvSpPr>
          <p:nvPr/>
        </p:nvSpPr>
        <p:spPr bwMode="auto">
          <a:xfrm rot="16200000">
            <a:off x="-562152" y="5292044"/>
            <a:ext cx="14302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CA" altLang="en-US" sz="1000" b="1" dirty="0">
                <a:latin typeface="Arial" charset="0"/>
              </a:rPr>
              <a:t>% of total TCR alpha</a:t>
            </a:r>
            <a:endParaRPr lang="fr-CA" altLang="en-US" sz="1000" b="1" dirty="0">
              <a:latin typeface="Arial" charset="0"/>
            </a:endParaRPr>
          </a:p>
        </p:txBody>
      </p:sp>
      <p:sp>
        <p:nvSpPr>
          <p:cNvPr id="15" name="ZoneTexte 34"/>
          <p:cNvSpPr txBox="1">
            <a:spLocks noChangeArrowheads="1"/>
          </p:cNvSpPr>
          <p:nvPr/>
        </p:nvSpPr>
        <p:spPr bwMode="auto">
          <a:xfrm rot="16200000">
            <a:off x="-546805" y="7008261"/>
            <a:ext cx="135966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CA" altLang="en-US" sz="1000" b="1" dirty="0">
                <a:latin typeface="Arial" charset="0"/>
              </a:rPr>
              <a:t>% of total TCR beta</a:t>
            </a:r>
            <a:endParaRPr lang="fr-CA" altLang="en-US" sz="1000" b="1" dirty="0">
              <a:latin typeface="Arial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667000" y="914400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L 2684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690360" y="4876800"/>
            <a:ext cx="6944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L 2688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33997961"/>
              </p:ext>
            </p:extLst>
          </p:nvPr>
        </p:nvGraphicFramePr>
        <p:xfrm>
          <a:off x="264184" y="815587"/>
          <a:ext cx="6516644" cy="18763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" name="Chart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3042672"/>
              </p:ext>
            </p:extLst>
          </p:nvPr>
        </p:nvGraphicFramePr>
        <p:xfrm>
          <a:off x="264184" y="2724729"/>
          <a:ext cx="6519430" cy="16948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3" name="Chart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3820239"/>
              </p:ext>
            </p:extLst>
          </p:nvPr>
        </p:nvGraphicFramePr>
        <p:xfrm>
          <a:off x="264184" y="4771304"/>
          <a:ext cx="6517616" cy="20026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Char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3177149"/>
              </p:ext>
            </p:extLst>
          </p:nvPr>
        </p:nvGraphicFramePr>
        <p:xfrm>
          <a:off x="190376" y="6485184"/>
          <a:ext cx="6587442" cy="1676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6" name="Rectangle 15"/>
          <p:cNvSpPr/>
          <p:nvPr/>
        </p:nvSpPr>
        <p:spPr>
          <a:xfrm>
            <a:off x="18934" y="8208779"/>
            <a:ext cx="67519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the level of expression of 45 V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  <a:sym typeface="Symbol"/>
              </a:rPr>
              <a:t>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46 V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enes in RNA isolated from the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 pre-REP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IL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ines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monstrated no difference in the clonal diversity obtained pos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REP independently of the device used for expansion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ach TIL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ne denoted by a 4 digit number was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derived from a different patient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Last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 TIL lines out of the 4 show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711884" y="1077658"/>
            <a:ext cx="6495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700" i="1" baseline="-14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= 0.9352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710890" y="2971800"/>
            <a:ext cx="6495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700" i="1" baseline="-14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= 0.9376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706625" y="5065060"/>
            <a:ext cx="6495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700" i="1" baseline="-14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= 0.9506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710890" y="6745725"/>
            <a:ext cx="6495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i="1" dirty="0" smtClean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sz="700" i="1" baseline="-14000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= 0.9780 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02677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7</TotalTime>
  <Words>109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Symbol</vt:lpstr>
      <vt:lpstr>Office Theme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orget,Marie Andree</dc:creator>
  <cp:lastModifiedBy>Bernatchez,Chantale</cp:lastModifiedBy>
  <cp:revision>33</cp:revision>
  <dcterms:created xsi:type="dcterms:W3CDTF">2014-11-11T16:05:36Z</dcterms:created>
  <dcterms:modified xsi:type="dcterms:W3CDTF">2015-05-07T04:16:47Z</dcterms:modified>
</cp:coreProperties>
</file>